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5" r:id="rId3"/>
  </p:sldIdLst>
  <p:sldSz cx="6858000" cy="9144000" type="screen4x3"/>
  <p:notesSz cx="7026275" cy="93122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56A2C"/>
    <a:srgbClr val="960000"/>
    <a:srgbClr val="1403F3"/>
    <a:srgbClr val="1A04BC"/>
    <a:srgbClr val="4285E8"/>
    <a:srgbClr val="72A2DC"/>
    <a:srgbClr val="78A6DE"/>
    <a:srgbClr val="8CAF47"/>
    <a:srgbClr val="5C732F"/>
    <a:srgbClr val="99BA5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14" autoAdjust="0"/>
    <p:restoredTop sz="87768" autoAdjust="0"/>
  </p:normalViewPr>
  <p:slideViewPr>
    <p:cSldViewPr>
      <p:cViewPr varScale="1">
        <p:scale>
          <a:sx n="72" d="100"/>
          <a:sy n="72" d="100"/>
        </p:scale>
        <p:origin x="1770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labs\bremner_lab\shared\bremnerarray01\Common\Joel\COVID-19\Data%20-%20RT-PCR\Summary%20graphs-05-07-20-23-0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labs\bremner_lab\shared\bremnerarray01\Common\Joel\COVID-19\Data%20-%20RT-PCR\Summary%20graph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labs\bremner_lab\shared\bremnerarray01\Common\Joel\COVID-19\Paper%20Figs\comparing%2096%20&amp;%20384%20well%20-%20Norgen%20ki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ad\labs\bremner_lab\shared\bremnerarray01\Common\Joel\COVID-19\Paper\data\comparing%2096%20&amp;%20384%20well%20-%20Norgen%20kit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%20HD:Users:MIC:Documents:-FILES-Active:Myron's_files:_Laboratory:COVID-19_screening:_Manuscript:diagnostic%20paper%20data%20for%20figures-sh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aron\Documents\COVID\diagnostic%20paper%20data%20for%20figures-sh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Sharon\Documents\COVID\diagnostic%20paper%20data%20for%20figures-sh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360836937636318"/>
          <c:y val="0.1111111111111111"/>
          <c:w val="0.75400638300494127"/>
          <c:h val="0.541655284093606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aqman primer tests'!$A$24</c:f>
              <c:strCache>
                <c:ptCount val="1"/>
                <c:pt idx="0">
                  <c:v>55°C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aqman primer tests'!$B$28:$F$28</c:f>
                <c:numCache>
                  <c:formatCode>General</c:formatCode>
                  <c:ptCount val="5"/>
                  <c:pt idx="0">
                    <c:v>0.1174022944557202</c:v>
                  </c:pt>
                  <c:pt idx="1">
                    <c:v>0.70208946031742425</c:v>
                  </c:pt>
                  <c:pt idx="2">
                    <c:v>0.66273929961635869</c:v>
                  </c:pt>
                  <c:pt idx="3">
                    <c:v>0.55334750345467398</c:v>
                  </c:pt>
                  <c:pt idx="4">
                    <c:v>1.2272500446530592</c:v>
                  </c:pt>
                </c:numCache>
              </c:numRef>
            </c:plus>
            <c:minus>
              <c:numRef>
                <c:f>'Taqman primer tests'!$B$28:$F$28</c:f>
                <c:numCache>
                  <c:formatCode>General</c:formatCode>
                  <c:ptCount val="5"/>
                  <c:pt idx="0">
                    <c:v>0.1174022944557202</c:v>
                  </c:pt>
                  <c:pt idx="1">
                    <c:v>0.70208946031742425</c:v>
                  </c:pt>
                  <c:pt idx="2">
                    <c:v>0.66273929961635869</c:v>
                  </c:pt>
                  <c:pt idx="3">
                    <c:v>0.55334750345467398</c:v>
                  </c:pt>
                  <c:pt idx="4">
                    <c:v>1.2272500446530592</c:v>
                  </c:pt>
                </c:numCache>
              </c:numRef>
            </c:minus>
          </c:errBars>
          <c:cat>
            <c:strRef>
              <c:f>'Taqman primer tests'!$B$23:$F$23</c:f>
              <c:strCache>
                <c:ptCount val="5"/>
                <c:pt idx="0">
                  <c:v>N1</c:v>
                </c:pt>
                <c:pt idx="1">
                  <c:v>N2</c:v>
                </c:pt>
                <c:pt idx="2">
                  <c:v>E_Sarbeco</c:v>
                </c:pt>
                <c:pt idx="3">
                  <c:v>Orf1_HKU</c:v>
                </c:pt>
                <c:pt idx="4">
                  <c:v>N_Pearson</c:v>
                </c:pt>
              </c:strCache>
            </c:strRef>
          </c:cat>
          <c:val>
            <c:numRef>
              <c:f>'Taqman primer tests'!$B$24:$F$24</c:f>
              <c:numCache>
                <c:formatCode>###0.00;\-###0.00</c:formatCode>
                <c:ptCount val="5"/>
                <c:pt idx="0" formatCode="General">
                  <c:v>33.883015958536497</c:v>
                </c:pt>
                <c:pt idx="1">
                  <c:v>34.611452218390049</c:v>
                </c:pt>
                <c:pt idx="2" formatCode="General">
                  <c:v>32.156372547082448</c:v>
                </c:pt>
                <c:pt idx="3" formatCode="General">
                  <c:v>38.988724227954549</c:v>
                </c:pt>
                <c:pt idx="4" formatCode="General">
                  <c:v>36.2772031712143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46F-4142-A611-A7CC1D9C1CEE}"/>
            </c:ext>
          </c:extLst>
        </c:ser>
        <c:ser>
          <c:idx val="1"/>
          <c:order val="1"/>
          <c:tx>
            <c:strRef>
              <c:f>'Taqman primer tests'!$A$25</c:f>
              <c:strCache>
                <c:ptCount val="1"/>
                <c:pt idx="0">
                  <c:v>57°C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Taqman primer tests'!$B$29:$F$29</c:f>
                <c:numCache>
                  <c:formatCode>General</c:formatCode>
                  <c:ptCount val="5"/>
                  <c:pt idx="0">
                    <c:v>9.8282538555407987E-4</c:v>
                  </c:pt>
                  <c:pt idx="1">
                    <c:v>0.22532691749460834</c:v>
                  </c:pt>
                  <c:pt idx="2">
                    <c:v>0.2332945624551328</c:v>
                  </c:pt>
                  <c:pt idx="3">
                    <c:v>1.0485990655471291</c:v>
                  </c:pt>
                  <c:pt idx="4">
                    <c:v>0.15008746045758256</c:v>
                  </c:pt>
                </c:numCache>
              </c:numRef>
            </c:plus>
            <c:minus>
              <c:numRef>
                <c:f>'Taqman primer tests'!$B$29:$F$29</c:f>
                <c:numCache>
                  <c:formatCode>General</c:formatCode>
                  <c:ptCount val="5"/>
                  <c:pt idx="0">
                    <c:v>9.8282538555407987E-4</c:v>
                  </c:pt>
                  <c:pt idx="1">
                    <c:v>0.22532691749460834</c:v>
                  </c:pt>
                  <c:pt idx="2">
                    <c:v>0.2332945624551328</c:v>
                  </c:pt>
                  <c:pt idx="3">
                    <c:v>1.0485990655471291</c:v>
                  </c:pt>
                  <c:pt idx="4">
                    <c:v>0.15008746045758256</c:v>
                  </c:pt>
                </c:numCache>
              </c:numRef>
            </c:minus>
          </c:errBars>
          <c:cat>
            <c:strRef>
              <c:f>'Taqman primer tests'!$B$23:$F$23</c:f>
              <c:strCache>
                <c:ptCount val="5"/>
                <c:pt idx="0">
                  <c:v>N1</c:v>
                </c:pt>
                <c:pt idx="1">
                  <c:v>N2</c:v>
                </c:pt>
                <c:pt idx="2">
                  <c:v>E_Sarbeco</c:v>
                </c:pt>
                <c:pt idx="3">
                  <c:v>Orf1_HKU</c:v>
                </c:pt>
                <c:pt idx="4">
                  <c:v>N_Pearson</c:v>
                </c:pt>
              </c:strCache>
            </c:strRef>
          </c:cat>
          <c:val>
            <c:numRef>
              <c:f>'Taqman primer tests'!$B$25:$F$25</c:f>
              <c:numCache>
                <c:formatCode>###0.00;\-###0.00</c:formatCode>
                <c:ptCount val="5"/>
                <c:pt idx="0" formatCode="General">
                  <c:v>33.704305037505151</c:v>
                </c:pt>
                <c:pt idx="1">
                  <c:v>34.559330191344301</c:v>
                </c:pt>
                <c:pt idx="2" formatCode="General">
                  <c:v>31.669964167125976</c:v>
                </c:pt>
                <c:pt idx="3" formatCode="General">
                  <c:v>38.78352849000575</c:v>
                </c:pt>
                <c:pt idx="4" formatCode="General">
                  <c:v>35.8088721389393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46F-4142-A611-A7CC1D9C1CEE}"/>
            </c:ext>
          </c:extLst>
        </c:ser>
        <c:ser>
          <c:idx val="2"/>
          <c:order val="2"/>
          <c:tx>
            <c:strRef>
              <c:f>'Taqman primer tests'!$A$26</c:f>
              <c:strCache>
                <c:ptCount val="1"/>
                <c:pt idx="0">
                  <c:v>59°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Taqman primer tests'!$B$30:$F$30</c:f>
                <c:numCache>
                  <c:formatCode>General</c:formatCode>
                  <c:ptCount val="5"/>
                  <c:pt idx="0">
                    <c:v>0.20714268669647215</c:v>
                  </c:pt>
                  <c:pt idx="1">
                    <c:v>0.53279392813569992</c:v>
                  </c:pt>
                  <c:pt idx="2">
                    <c:v>0.32155592382445075</c:v>
                  </c:pt>
                  <c:pt idx="3">
                    <c:v>1.3527890104854512</c:v>
                  </c:pt>
                  <c:pt idx="4">
                    <c:v>1.1822051592504594</c:v>
                  </c:pt>
                </c:numCache>
              </c:numRef>
            </c:plus>
            <c:minus>
              <c:numRef>
                <c:f>'Taqman primer tests'!$B$30:$F$30</c:f>
                <c:numCache>
                  <c:formatCode>General</c:formatCode>
                  <c:ptCount val="5"/>
                  <c:pt idx="0">
                    <c:v>0.20714268669647215</c:v>
                  </c:pt>
                  <c:pt idx="1">
                    <c:v>0.53279392813569992</c:v>
                  </c:pt>
                  <c:pt idx="2">
                    <c:v>0.32155592382445075</c:v>
                  </c:pt>
                  <c:pt idx="3">
                    <c:v>1.3527890104854512</c:v>
                  </c:pt>
                  <c:pt idx="4">
                    <c:v>1.1822051592504594</c:v>
                  </c:pt>
                </c:numCache>
              </c:numRef>
            </c:minus>
          </c:errBars>
          <c:cat>
            <c:strRef>
              <c:f>'Taqman primer tests'!$B$23:$F$23</c:f>
              <c:strCache>
                <c:ptCount val="5"/>
                <c:pt idx="0">
                  <c:v>N1</c:v>
                </c:pt>
                <c:pt idx="1">
                  <c:v>N2</c:v>
                </c:pt>
                <c:pt idx="2">
                  <c:v>E_Sarbeco</c:v>
                </c:pt>
                <c:pt idx="3">
                  <c:v>Orf1_HKU</c:v>
                </c:pt>
                <c:pt idx="4">
                  <c:v>N_Pearson</c:v>
                </c:pt>
              </c:strCache>
            </c:strRef>
          </c:cat>
          <c:val>
            <c:numRef>
              <c:f>'Taqman primer tests'!$B$26:$F$26</c:f>
              <c:numCache>
                <c:formatCode>###0.00;\-###0.00</c:formatCode>
                <c:ptCount val="5"/>
                <c:pt idx="0" formatCode="General">
                  <c:v>34.321471998436273</c:v>
                </c:pt>
                <c:pt idx="1">
                  <c:v>34.526742199559777</c:v>
                </c:pt>
                <c:pt idx="2" formatCode="General">
                  <c:v>31.287374374266975</c:v>
                </c:pt>
                <c:pt idx="3" formatCode="General">
                  <c:v>38.0365662828289</c:v>
                </c:pt>
                <c:pt idx="4" formatCode="General">
                  <c:v>37.2509452848597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46F-4142-A611-A7CC1D9C1C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4597008"/>
        <c:axId val="414598968"/>
      </c:barChart>
      <c:catAx>
        <c:axId val="4145970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98968"/>
        <c:crosses val="autoZero"/>
        <c:auto val="1"/>
        <c:lblAlgn val="ctr"/>
        <c:lblOffset val="100"/>
        <c:noMultiLvlLbl val="0"/>
      </c:catAx>
      <c:valAx>
        <c:axId val="414598968"/>
        <c:scaling>
          <c:orientation val="minMax"/>
          <c:max val="41"/>
          <c:min val="2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Expression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/>
          <c:overlay val="0"/>
        </c:title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97008"/>
        <c:crosses val="autoZero"/>
        <c:crossBetween val="between"/>
        <c:majorUnit val="5"/>
      </c:valAx>
    </c:plotArea>
    <c:legend>
      <c:legendPos val="r"/>
      <c:layout>
        <c:manualLayout>
          <c:xMode val="edge"/>
          <c:yMode val="edge"/>
          <c:x val="0.19972151368402893"/>
          <c:y val="5.2623562327064541E-2"/>
          <c:w val="0.21193449410373"/>
          <c:h val="0.21635131543489239"/>
        </c:manualLayout>
      </c:layout>
      <c:overlay val="1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709039331442154"/>
          <c:y val="5.1400554097404488E-2"/>
          <c:w val="0.69140982391576578"/>
          <c:h val="0.734244639583837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orgen vs Qiagen extract'!$U$1</c:f>
              <c:strCache>
                <c:ptCount val="1"/>
                <c:pt idx="0">
                  <c:v>Norgen Extractio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orgen vs Qiagen extract'!$AA$2:$AA$9</c:f>
                <c:numCache>
                  <c:formatCode>General</c:formatCode>
                  <c:ptCount val="8"/>
                  <c:pt idx="4">
                    <c:v>0.77781745930520074</c:v>
                  </c:pt>
                  <c:pt idx="6">
                    <c:v>0.91216774773064568</c:v>
                  </c:pt>
                  <c:pt idx="7">
                    <c:v>1.0323759005323601</c:v>
                  </c:pt>
                </c:numCache>
              </c:numRef>
            </c:plus>
            <c:minus>
              <c:numRef>
                <c:f>'Norgen vs Qiagen extract'!$AA$2:$AA$9</c:f>
                <c:numCache>
                  <c:formatCode>General</c:formatCode>
                  <c:ptCount val="8"/>
                  <c:pt idx="4">
                    <c:v>0.77781745930520074</c:v>
                  </c:pt>
                  <c:pt idx="6">
                    <c:v>0.91216774773064568</c:v>
                  </c:pt>
                  <c:pt idx="7">
                    <c:v>1.0323759005323601</c:v>
                  </c:pt>
                </c:numCache>
              </c:numRef>
            </c:minus>
          </c:errBars>
          <c:cat>
            <c:strRef>
              <c:f>'Norgen vs Qiagen extract'!$R$2:$R$9</c:f>
              <c:strCache>
                <c:ptCount val="8"/>
                <c:pt idx="0">
                  <c:v>L013</c:v>
                </c:pt>
                <c:pt idx="1">
                  <c:v>L013F</c:v>
                </c:pt>
                <c:pt idx="2">
                  <c:v>L014</c:v>
                </c:pt>
                <c:pt idx="3">
                  <c:v>L017</c:v>
                </c:pt>
                <c:pt idx="4">
                  <c:v>L015</c:v>
                </c:pt>
                <c:pt idx="5">
                  <c:v>L016</c:v>
                </c:pt>
                <c:pt idx="6">
                  <c:v>L018</c:v>
                </c:pt>
                <c:pt idx="7">
                  <c:v>L019</c:v>
                </c:pt>
              </c:strCache>
            </c:strRef>
          </c:cat>
          <c:val>
            <c:numRef>
              <c:f>'Norgen vs Qiagen extract'!$U$2:$U$9</c:f>
              <c:numCache>
                <c:formatCode>General</c:formatCode>
                <c:ptCount val="8"/>
                <c:pt idx="4">
                  <c:v>28.83</c:v>
                </c:pt>
                <c:pt idx="5">
                  <c:v>26.14</c:v>
                </c:pt>
                <c:pt idx="6">
                  <c:v>15.025</c:v>
                </c:pt>
                <c:pt idx="7">
                  <c:v>26.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56A-4222-84F4-52974D9E48B9}"/>
            </c:ext>
          </c:extLst>
        </c:ser>
        <c:ser>
          <c:idx val="1"/>
          <c:order val="1"/>
          <c:tx>
            <c:strRef>
              <c:f>'Norgen vs Qiagen extract'!$V$1</c:f>
              <c:strCache>
                <c:ptCount val="1"/>
                <c:pt idx="0">
                  <c:v>Qiagen RNeasy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orgen vs Qiagen extract'!$AB$2:$AB$9</c:f>
                <c:numCache>
                  <c:formatCode>General</c:formatCode>
                  <c:ptCount val="8"/>
                  <c:pt idx="4">
                    <c:v>0.90509667991878162</c:v>
                  </c:pt>
                  <c:pt idx="6">
                    <c:v>0.79903066274079926</c:v>
                  </c:pt>
                  <c:pt idx="7">
                    <c:v>0.62932503525602523</c:v>
                  </c:pt>
                </c:numCache>
              </c:numRef>
            </c:plus>
            <c:minus>
              <c:numRef>
                <c:f>'Norgen vs Qiagen extract'!$AB$2:$AB$9</c:f>
                <c:numCache>
                  <c:formatCode>General</c:formatCode>
                  <c:ptCount val="8"/>
                  <c:pt idx="4">
                    <c:v>0.90509667991878162</c:v>
                  </c:pt>
                  <c:pt idx="6">
                    <c:v>0.79903066274079926</c:v>
                  </c:pt>
                  <c:pt idx="7">
                    <c:v>0.62932503525602523</c:v>
                  </c:pt>
                </c:numCache>
              </c:numRef>
            </c:minus>
          </c:errBars>
          <c:cat>
            <c:strRef>
              <c:f>'Norgen vs Qiagen extract'!$R$2:$R$9</c:f>
              <c:strCache>
                <c:ptCount val="8"/>
                <c:pt idx="0">
                  <c:v>L013</c:v>
                </c:pt>
                <c:pt idx="1">
                  <c:v>L013F</c:v>
                </c:pt>
                <c:pt idx="2">
                  <c:v>L014</c:v>
                </c:pt>
                <c:pt idx="3">
                  <c:v>L017</c:v>
                </c:pt>
                <c:pt idx="4">
                  <c:v>L015</c:v>
                </c:pt>
                <c:pt idx="5">
                  <c:v>L016</c:v>
                </c:pt>
                <c:pt idx="6">
                  <c:v>L018</c:v>
                </c:pt>
                <c:pt idx="7">
                  <c:v>L019</c:v>
                </c:pt>
              </c:strCache>
            </c:strRef>
          </c:cat>
          <c:val>
            <c:numRef>
              <c:f>'Norgen vs Qiagen extract'!$V$2:$V$9</c:f>
              <c:numCache>
                <c:formatCode>General</c:formatCode>
                <c:ptCount val="8"/>
                <c:pt idx="4">
                  <c:v>30.46</c:v>
                </c:pt>
                <c:pt idx="5">
                  <c:v>28.51</c:v>
                </c:pt>
                <c:pt idx="6">
                  <c:v>15.695</c:v>
                </c:pt>
                <c:pt idx="7">
                  <c:v>26.384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56A-4222-84F4-52974D9E48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4601320"/>
        <c:axId val="414529776"/>
      </c:barChart>
      <c:catAx>
        <c:axId val="4146013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29776"/>
        <c:crosses val="autoZero"/>
        <c:auto val="1"/>
        <c:lblAlgn val="ctr"/>
        <c:lblOffset val="100"/>
        <c:noMultiLvlLbl val="0"/>
      </c:catAx>
      <c:valAx>
        <c:axId val="414529776"/>
        <c:scaling>
          <c:orientation val="minMax"/>
          <c:min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N2</a:t>
                </a:r>
                <a:r>
                  <a:rPr lang="en-US" sz="900" baseline="0" dirty="0"/>
                  <a:t> primers</a:t>
                </a:r>
                <a:r>
                  <a:rPr lang="en-US" sz="900" dirty="0"/>
                  <a:t>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8.114186409057221E-3"/>
              <c:y val="0.1912860892388451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601320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21096884663548773"/>
          <c:y val="0"/>
          <c:w val="0.65790078969562216"/>
          <c:h val="0.14248773251169691"/>
        </c:manualLayout>
      </c:layout>
      <c:overlay val="1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7913140932938"/>
          <c:y val="5.6872053349812796E-2"/>
          <c:w val="0.49773884910661964"/>
          <c:h val="0.680324176852426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 1'!$K$9</c:f>
              <c:strCache>
                <c:ptCount val="1"/>
                <c:pt idx="0">
                  <c:v>96-well (20µl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heet 1'!$R$10:$R$14</c:f>
                <c:numCache>
                  <c:formatCode>General</c:formatCode>
                  <c:ptCount val="5"/>
                  <c:pt idx="0">
                    <c:v>0.33941125496954061</c:v>
                  </c:pt>
                  <c:pt idx="1">
                    <c:v>0.12020815280171177</c:v>
                  </c:pt>
                  <c:pt idx="2">
                    <c:v>0.4454772721475217</c:v>
                  </c:pt>
                  <c:pt idx="3">
                    <c:v>0.31819805153394337</c:v>
                  </c:pt>
                  <c:pt idx="4">
                    <c:v>0</c:v>
                  </c:pt>
                </c:numCache>
              </c:numRef>
            </c:plus>
            <c:minus>
              <c:numRef>
                <c:f>'sheet 1'!$R$10:$R$14</c:f>
                <c:numCache>
                  <c:formatCode>General</c:formatCode>
                  <c:ptCount val="5"/>
                  <c:pt idx="0">
                    <c:v>0.33941125496954061</c:v>
                  </c:pt>
                  <c:pt idx="1">
                    <c:v>0.12020815280171177</c:v>
                  </c:pt>
                  <c:pt idx="2">
                    <c:v>0.4454772721475217</c:v>
                  </c:pt>
                  <c:pt idx="3">
                    <c:v>0.31819805153394337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sheet 1'!$J$10:$J$14</c:f>
              <c:strCache>
                <c:ptCount val="5"/>
                <c:pt idx="0">
                  <c:v>20,000</c:v>
                </c:pt>
                <c:pt idx="1">
                  <c:v>2,000</c:v>
                </c:pt>
                <c:pt idx="2">
                  <c:v>200</c:v>
                </c:pt>
                <c:pt idx="3">
                  <c:v>20</c:v>
                </c:pt>
                <c:pt idx="4">
                  <c:v>NTC</c:v>
                </c:pt>
              </c:strCache>
            </c:strRef>
          </c:cat>
          <c:val>
            <c:numRef>
              <c:f>'sheet 1'!$K$10:$K$14</c:f>
              <c:numCache>
                <c:formatCode>General</c:formatCode>
                <c:ptCount val="5"/>
                <c:pt idx="0">
                  <c:v>27.91</c:v>
                </c:pt>
                <c:pt idx="1">
                  <c:v>31.454999999999998</c:v>
                </c:pt>
                <c:pt idx="2">
                  <c:v>34.445</c:v>
                </c:pt>
                <c:pt idx="3">
                  <c:v>37.965000000000003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625-4F5A-9987-14D802128BB2}"/>
            </c:ext>
          </c:extLst>
        </c:ser>
        <c:ser>
          <c:idx val="1"/>
          <c:order val="1"/>
          <c:tx>
            <c:strRef>
              <c:f>'sheet 1'!$L$9</c:f>
              <c:strCache>
                <c:ptCount val="1"/>
                <c:pt idx="0">
                  <c:v>384-well (10µl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sheet 1'!$S$10:$S$14</c:f>
                <c:numCache>
                  <c:formatCode>General</c:formatCode>
                  <c:ptCount val="5"/>
                  <c:pt idx="0">
                    <c:v>0.14142135623731153</c:v>
                  </c:pt>
                  <c:pt idx="1">
                    <c:v>0</c:v>
                  </c:pt>
                  <c:pt idx="2">
                    <c:v>0.46669047558312399</c:v>
                  </c:pt>
                  <c:pt idx="3">
                    <c:v>3.5708892449920633</c:v>
                  </c:pt>
                  <c:pt idx="4">
                    <c:v>0</c:v>
                  </c:pt>
                </c:numCache>
              </c:numRef>
            </c:plus>
            <c:minus>
              <c:numRef>
                <c:f>'sheet 1'!$S$10:$S$14</c:f>
                <c:numCache>
                  <c:formatCode>General</c:formatCode>
                  <c:ptCount val="5"/>
                  <c:pt idx="0">
                    <c:v>0.14142135623731153</c:v>
                  </c:pt>
                  <c:pt idx="1">
                    <c:v>0</c:v>
                  </c:pt>
                  <c:pt idx="2">
                    <c:v>0.46669047558312399</c:v>
                  </c:pt>
                  <c:pt idx="3">
                    <c:v>3.5708892449920633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sheet 1'!$J$10:$J$14</c:f>
              <c:strCache>
                <c:ptCount val="5"/>
                <c:pt idx="0">
                  <c:v>20,000</c:v>
                </c:pt>
                <c:pt idx="1">
                  <c:v>2,000</c:v>
                </c:pt>
                <c:pt idx="2">
                  <c:v>200</c:v>
                </c:pt>
                <c:pt idx="3">
                  <c:v>20</c:v>
                </c:pt>
                <c:pt idx="4">
                  <c:v>NTC</c:v>
                </c:pt>
              </c:strCache>
            </c:strRef>
          </c:cat>
          <c:val>
            <c:numRef>
              <c:f>'sheet 1'!$L$10:$L$14</c:f>
              <c:numCache>
                <c:formatCode>General</c:formatCode>
                <c:ptCount val="5"/>
                <c:pt idx="0">
                  <c:v>27.16</c:v>
                </c:pt>
                <c:pt idx="1">
                  <c:v>30.51</c:v>
                </c:pt>
                <c:pt idx="2">
                  <c:v>33.519999999999996</c:v>
                </c:pt>
                <c:pt idx="3">
                  <c:v>38.055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625-4F5A-9987-14D802128B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4530952"/>
        <c:axId val="414530168"/>
      </c:barChart>
      <c:catAx>
        <c:axId val="4145309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 dirty="0"/>
                  <a:t>viral </a:t>
                </a:r>
                <a:r>
                  <a:rPr lang="en-US" sz="900" dirty="0" smtClean="0"/>
                  <a:t>copies/</a:t>
                </a:r>
                <a:r>
                  <a:rPr lang="el-GR" sz="900" dirty="0" smtClean="0">
                    <a:latin typeface="Calibri"/>
                    <a:cs typeface="Calibri"/>
                  </a:rPr>
                  <a:t>μ</a:t>
                </a:r>
                <a:r>
                  <a:rPr lang="en-US" sz="900" dirty="0" smtClean="0"/>
                  <a:t>l</a:t>
                </a:r>
                <a:endParaRPr lang="en-US" sz="900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30168"/>
        <c:crosses val="autoZero"/>
        <c:auto val="1"/>
        <c:lblAlgn val="ctr"/>
        <c:lblOffset val="100"/>
        <c:noMultiLvlLbl val="0"/>
      </c:catAx>
      <c:valAx>
        <c:axId val="414530168"/>
        <c:scaling>
          <c:orientation val="minMax"/>
          <c:min val="1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N1 primers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309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7913140932938"/>
          <c:y val="5.6872053349812796E-2"/>
          <c:w val="0.49773884910661964"/>
          <c:h val="0.680324176852426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 1'!$O$9</c:f>
              <c:strCache>
                <c:ptCount val="1"/>
                <c:pt idx="0">
                  <c:v>96-well (20µl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heet 1'!$U$10:$U$14</c:f>
                <c:numCache>
                  <c:formatCode>General</c:formatCode>
                  <c:ptCount val="5"/>
                  <c:pt idx="0">
                    <c:v>0.27577164466275395</c:v>
                  </c:pt>
                  <c:pt idx="1">
                    <c:v>0.24041630560342606</c:v>
                  </c:pt>
                  <c:pt idx="2">
                    <c:v>5.6568542494922595E-2</c:v>
                  </c:pt>
                  <c:pt idx="3">
                    <c:v>3.5355339059330394E-2</c:v>
                  </c:pt>
                  <c:pt idx="4">
                    <c:v>0</c:v>
                  </c:pt>
                </c:numCache>
              </c:numRef>
            </c:plus>
            <c:minus>
              <c:numRef>
                <c:f>'sheet 1'!$U$10:$U$14</c:f>
                <c:numCache>
                  <c:formatCode>General</c:formatCode>
                  <c:ptCount val="5"/>
                  <c:pt idx="0">
                    <c:v>0.27577164466275395</c:v>
                  </c:pt>
                  <c:pt idx="1">
                    <c:v>0.24041630560342606</c:v>
                  </c:pt>
                  <c:pt idx="2">
                    <c:v>5.6568542494922595E-2</c:v>
                  </c:pt>
                  <c:pt idx="3">
                    <c:v>3.5355339059330394E-2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sheet 1'!$N$10:$N$14</c:f>
              <c:strCache>
                <c:ptCount val="5"/>
                <c:pt idx="0">
                  <c:v>20,000</c:v>
                </c:pt>
                <c:pt idx="1">
                  <c:v>2,000</c:v>
                </c:pt>
                <c:pt idx="2">
                  <c:v>200</c:v>
                </c:pt>
                <c:pt idx="3">
                  <c:v>20</c:v>
                </c:pt>
                <c:pt idx="4">
                  <c:v>NTC</c:v>
                </c:pt>
              </c:strCache>
            </c:strRef>
          </c:cat>
          <c:val>
            <c:numRef>
              <c:f>'sheet 1'!$O$10:$O$14</c:f>
              <c:numCache>
                <c:formatCode>General</c:formatCode>
                <c:ptCount val="5"/>
                <c:pt idx="0">
                  <c:v>27.925000000000001</c:v>
                </c:pt>
                <c:pt idx="1">
                  <c:v>31.22</c:v>
                </c:pt>
                <c:pt idx="2">
                  <c:v>34.75</c:v>
                </c:pt>
                <c:pt idx="3">
                  <c:v>37.685000000000002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FE2-4696-A7B4-AC20AE81B310}"/>
            </c:ext>
          </c:extLst>
        </c:ser>
        <c:ser>
          <c:idx val="1"/>
          <c:order val="1"/>
          <c:tx>
            <c:strRef>
              <c:f>'sheet 1'!$P$9</c:f>
              <c:strCache>
                <c:ptCount val="1"/>
                <c:pt idx="0">
                  <c:v>384-well (10µl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sheet 1'!$V$10:$V$14</c:f>
                <c:numCache>
                  <c:formatCode>General</c:formatCode>
                  <c:ptCount val="5"/>
                  <c:pt idx="0">
                    <c:v>0.21213203435596475</c:v>
                  </c:pt>
                  <c:pt idx="1">
                    <c:v>0.36062445840514029</c:v>
                  </c:pt>
                  <c:pt idx="2">
                    <c:v>4.9497474683058526E-2</c:v>
                  </c:pt>
                  <c:pt idx="3">
                    <c:v>0.62932503525602768</c:v>
                  </c:pt>
                  <c:pt idx="4">
                    <c:v>0</c:v>
                  </c:pt>
                </c:numCache>
              </c:numRef>
            </c:plus>
            <c:minus>
              <c:numRef>
                <c:f>'sheet 1'!$V$10:$V$14</c:f>
                <c:numCache>
                  <c:formatCode>General</c:formatCode>
                  <c:ptCount val="5"/>
                  <c:pt idx="0">
                    <c:v>0.21213203435596475</c:v>
                  </c:pt>
                  <c:pt idx="1">
                    <c:v>0.36062445840514029</c:v>
                  </c:pt>
                  <c:pt idx="2">
                    <c:v>4.9497474683058526E-2</c:v>
                  </c:pt>
                  <c:pt idx="3">
                    <c:v>0.62932503525602768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sheet 1'!$N$10:$N$14</c:f>
              <c:strCache>
                <c:ptCount val="5"/>
                <c:pt idx="0">
                  <c:v>20,000</c:v>
                </c:pt>
                <c:pt idx="1">
                  <c:v>2,000</c:v>
                </c:pt>
                <c:pt idx="2">
                  <c:v>200</c:v>
                </c:pt>
                <c:pt idx="3">
                  <c:v>20</c:v>
                </c:pt>
                <c:pt idx="4">
                  <c:v>NTC</c:v>
                </c:pt>
              </c:strCache>
            </c:strRef>
          </c:cat>
          <c:val>
            <c:numRef>
              <c:f>'sheet 1'!$P$10:$P$14</c:f>
              <c:numCache>
                <c:formatCode>General</c:formatCode>
                <c:ptCount val="5"/>
                <c:pt idx="0">
                  <c:v>27.1</c:v>
                </c:pt>
                <c:pt idx="1">
                  <c:v>30.594999999999999</c:v>
                </c:pt>
                <c:pt idx="2">
                  <c:v>34.084999999999994</c:v>
                </c:pt>
                <c:pt idx="3">
                  <c:v>37.655000000000001</c:v>
                </c:pt>
                <c:pt idx="4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FE2-4696-A7B4-AC20AE81B3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4532912"/>
        <c:axId val="414531344"/>
      </c:barChart>
      <c:catAx>
        <c:axId val="4145329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 dirty="0"/>
                  <a:t>viral </a:t>
                </a:r>
                <a:r>
                  <a:rPr lang="en-US" sz="900" dirty="0" smtClean="0"/>
                  <a:t>copies/µl</a:t>
                </a:r>
                <a:endParaRPr lang="en-US" sz="900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31344"/>
        <c:crosses val="autoZero"/>
        <c:auto val="1"/>
        <c:lblAlgn val="ctr"/>
        <c:lblOffset val="100"/>
        <c:noMultiLvlLbl val="0"/>
      </c:catAx>
      <c:valAx>
        <c:axId val="414531344"/>
        <c:scaling>
          <c:orientation val="minMax"/>
          <c:min val="1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 dirty="0"/>
                  <a:t>N2 primers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14532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0389730695428"/>
          <c:y val="0.171713116452549"/>
          <c:w val="0.65731136443765403"/>
          <c:h val="0.66364502720421803"/>
        </c:manualLayout>
      </c:layout>
      <c:lineChart>
        <c:grouping val="standard"/>
        <c:varyColors val="0"/>
        <c:ser>
          <c:idx val="1"/>
          <c:order val="1"/>
          <c:tx>
            <c:strRef>
              <c:f>'Copy number'!$D$3</c:f>
              <c:strCache>
                <c:ptCount val="1"/>
                <c:pt idx="0">
                  <c:v>S1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Copy number'!$C$4:$C$10</c:f>
              <c:strCache>
                <c:ptCount val="7"/>
                <c:pt idx="0">
                  <c:v>L021</c:v>
                </c:pt>
                <c:pt idx="1">
                  <c:v>L024</c:v>
                </c:pt>
                <c:pt idx="2">
                  <c:v>L028</c:v>
                </c:pt>
                <c:pt idx="3">
                  <c:v>L029</c:v>
                </c:pt>
                <c:pt idx="4">
                  <c:v>L031</c:v>
                </c:pt>
                <c:pt idx="5">
                  <c:v>L032</c:v>
                </c:pt>
                <c:pt idx="6">
                  <c:v>L033</c:v>
                </c:pt>
              </c:strCache>
            </c:strRef>
          </c:cat>
          <c:val>
            <c:numRef>
              <c:f>'Copy number'!$D$4:$D$10</c:f>
              <c:numCache>
                <c:formatCode>General</c:formatCode>
                <c:ptCount val="7"/>
                <c:pt idx="0">
                  <c:v>60</c:v>
                </c:pt>
                <c:pt idx="1">
                  <c:v>8440</c:v>
                </c:pt>
                <c:pt idx="2">
                  <c:v>98</c:v>
                </c:pt>
                <c:pt idx="3">
                  <c:v>11880</c:v>
                </c:pt>
                <c:pt idx="4">
                  <c:v>114800</c:v>
                </c:pt>
                <c:pt idx="5">
                  <c:v>24.56</c:v>
                </c:pt>
                <c:pt idx="6">
                  <c:v>47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772-4B1A-893C-F29F732573DE}"/>
            </c:ext>
          </c:extLst>
        </c:ser>
        <c:ser>
          <c:idx val="2"/>
          <c:order val="2"/>
          <c:tx>
            <c:strRef>
              <c:f>'Copy number'!$E$3</c:f>
              <c:strCache>
                <c:ptCount val="1"/>
                <c:pt idx="0">
                  <c:v>SH N1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Copy number'!$C$4:$C$10</c:f>
              <c:strCache>
                <c:ptCount val="7"/>
                <c:pt idx="0">
                  <c:v>L021</c:v>
                </c:pt>
                <c:pt idx="1">
                  <c:v>L024</c:v>
                </c:pt>
                <c:pt idx="2">
                  <c:v>L028</c:v>
                </c:pt>
                <c:pt idx="3">
                  <c:v>L029</c:v>
                </c:pt>
                <c:pt idx="4">
                  <c:v>L031</c:v>
                </c:pt>
                <c:pt idx="5">
                  <c:v>L032</c:v>
                </c:pt>
                <c:pt idx="6">
                  <c:v>L033</c:v>
                </c:pt>
              </c:strCache>
            </c:strRef>
          </c:cat>
          <c:val>
            <c:numRef>
              <c:f>'Copy number'!$E$4:$E$10</c:f>
              <c:numCache>
                <c:formatCode>General</c:formatCode>
                <c:ptCount val="7"/>
                <c:pt idx="0">
                  <c:v>81.599999999999994</c:v>
                </c:pt>
                <c:pt idx="1">
                  <c:v>9880</c:v>
                </c:pt>
                <c:pt idx="2">
                  <c:v>158</c:v>
                </c:pt>
                <c:pt idx="3">
                  <c:v>12200</c:v>
                </c:pt>
                <c:pt idx="4">
                  <c:v>119600</c:v>
                </c:pt>
                <c:pt idx="5">
                  <c:v>38.32</c:v>
                </c:pt>
                <c:pt idx="6">
                  <c:v>79.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772-4B1A-893C-F29F732573DE}"/>
            </c:ext>
          </c:extLst>
        </c:ser>
        <c:ser>
          <c:idx val="3"/>
          <c:order val="3"/>
          <c:tx>
            <c:strRef>
              <c:f>'Copy number'!$F$3</c:f>
              <c:strCache>
                <c:ptCount val="1"/>
                <c:pt idx="0">
                  <c:v>BGI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noFill/>
              </a:ln>
              <a:effectLst/>
            </c:spPr>
          </c:marker>
          <c:cat>
            <c:strRef>
              <c:f>'Copy number'!$C$4:$C$10</c:f>
              <c:strCache>
                <c:ptCount val="7"/>
                <c:pt idx="0">
                  <c:v>L021</c:v>
                </c:pt>
                <c:pt idx="1">
                  <c:v>L024</c:v>
                </c:pt>
                <c:pt idx="2">
                  <c:v>L028</c:v>
                </c:pt>
                <c:pt idx="3">
                  <c:v>L029</c:v>
                </c:pt>
                <c:pt idx="4">
                  <c:v>L031</c:v>
                </c:pt>
                <c:pt idx="5">
                  <c:v>L032</c:v>
                </c:pt>
                <c:pt idx="6">
                  <c:v>L033</c:v>
                </c:pt>
              </c:strCache>
            </c:strRef>
          </c:cat>
          <c:val>
            <c:numRef>
              <c:f>'Copy number'!$F$4:$F$10</c:f>
              <c:numCache>
                <c:formatCode>General</c:formatCode>
                <c:ptCount val="7"/>
                <c:pt idx="0">
                  <c:v>123</c:v>
                </c:pt>
                <c:pt idx="1">
                  <c:v>20693</c:v>
                </c:pt>
                <c:pt idx="2">
                  <c:v>301</c:v>
                </c:pt>
                <c:pt idx="3">
                  <c:v>50504</c:v>
                </c:pt>
                <c:pt idx="4">
                  <c:v>291443</c:v>
                </c:pt>
                <c:pt idx="5">
                  <c:v>53</c:v>
                </c:pt>
                <c:pt idx="6">
                  <c:v>16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772-4B1A-893C-F29F73257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14529384"/>
        <c:axId val="414531736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'[1]Probe v Sybr'!$C$3</c15:sqref>
                        </c15:formulaRef>
                      </c:ext>
                    </c:extLst>
                    <c:strCache>
                      <c:ptCount val="1"/>
                      <c:pt idx="0">
                        <c:v>Copies/uL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'Copy number'!$C$4:$C$10</c15:sqref>
                        </c15:formulaRef>
                      </c:ext>
                    </c:extLst>
                    <c:strCache>
                      <c:ptCount val="7"/>
                      <c:pt idx="0">
                        <c:v>L021</c:v>
                      </c:pt>
                      <c:pt idx="1">
                        <c:v>L024</c:v>
                      </c:pt>
                      <c:pt idx="2">
                        <c:v>L028</c:v>
                      </c:pt>
                      <c:pt idx="3">
                        <c:v>L029</c:v>
                      </c:pt>
                      <c:pt idx="4">
                        <c:v>L031</c:v>
                      </c:pt>
                      <c:pt idx="5">
                        <c:v>L032</c:v>
                      </c:pt>
                      <c:pt idx="6">
                        <c:v>L033</c:v>
                      </c:pt>
                    </c:strCache>
                  </c:strRef>
                </c:cat>
                <c: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[1]Probe v Sybr'!$C$4:$C$10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0</c:v>
                      </c:pt>
                      <c:pt idx="2">
                        <c:v>0</c:v>
                      </c:pt>
                      <c:pt idx="3">
                        <c:v>0</c:v>
                      </c:pt>
                      <c:pt idx="4">
                        <c:v>0</c:v>
                      </c:pt>
                      <c:pt idx="5">
                        <c:v>0</c:v>
                      </c:pt>
                      <c:pt idx="6">
                        <c:v>0</c:v>
                      </c:pt>
                    </c:numCache>
                  </c:numRef>
                </c:val>
                <c:smooth val="0"/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3-B772-4B1A-893C-F29F732573DE}"/>
                  </c:ext>
                </c:extLst>
              </c15:ser>
            </c15:filteredLineSeries>
          </c:ext>
        </c:extLst>
      </c:lineChart>
      <c:catAx>
        <c:axId val="414529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531736"/>
        <c:crosses val="autoZero"/>
        <c:auto val="1"/>
        <c:lblAlgn val="ctr"/>
        <c:lblOffset val="100"/>
        <c:noMultiLvlLbl val="0"/>
      </c:catAx>
      <c:valAx>
        <c:axId val="414531736"/>
        <c:scaling>
          <c:logBase val="10"/>
          <c:orientation val="minMax"/>
          <c:max val="1000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Copies /</a:t>
                </a:r>
                <a:r>
                  <a:rPr lang="en-US" baseline="0">
                    <a:solidFill>
                      <a:schemeClr val="tx1"/>
                    </a:solidFill>
                  </a:rPr>
                  <a:t> </a:t>
                </a:r>
                <a:r>
                  <a:rPr lang="el-GR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baseline="0">
                    <a:solidFill>
                      <a:schemeClr val="tx1"/>
                    </a:solidFill>
                  </a:rPr>
                  <a:t>L</a:t>
                </a:r>
                <a:endParaRPr lang="en-US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5293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0961899165589402"/>
          <c:y val="0.14308336994356399"/>
          <c:w val="0.15226252355710401"/>
          <c:h val="0.2135697264815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612944142806299"/>
          <c:y val="5.7938125133007001E-2"/>
          <c:w val="0.65743189939208302"/>
          <c:h val="0.73356126536814503"/>
        </c:manualLayout>
      </c:layout>
      <c:scatterChart>
        <c:scatterStyle val="lineMarker"/>
        <c:varyColors val="0"/>
        <c:ser>
          <c:idx val="0"/>
          <c:order val="0"/>
          <c:tx>
            <c:strRef>
              <c:f>'Clinical samples Cp'!$B$37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rgbClr val="00B050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96825967691205"/>
                  <c:y val="0.3852988795561539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Clinical samples Cp'!$A$50:$A$56</c:f>
              <c:numCache>
                <c:formatCode>General</c:formatCode>
                <c:ptCount val="7"/>
                <c:pt idx="0">
                  <c:v>28.63</c:v>
                </c:pt>
                <c:pt idx="1">
                  <c:v>21.64</c:v>
                </c:pt>
                <c:pt idx="2">
                  <c:v>27.67</c:v>
                </c:pt>
                <c:pt idx="3">
                  <c:v>21.33</c:v>
                </c:pt>
                <c:pt idx="4">
                  <c:v>18</c:v>
                </c:pt>
                <c:pt idx="5">
                  <c:v>29.74</c:v>
                </c:pt>
                <c:pt idx="6">
                  <c:v>28.68</c:v>
                </c:pt>
              </c:numCache>
            </c:numRef>
          </c:xVal>
          <c:yVal>
            <c:numRef>
              <c:f>'Clinical samples Cp'!$B$50:$B$56</c:f>
              <c:numCache>
                <c:formatCode>General</c:formatCode>
                <c:ptCount val="7"/>
                <c:pt idx="0">
                  <c:v>29.244075507508651</c:v>
                </c:pt>
                <c:pt idx="1">
                  <c:v>22.3087603134672</c:v>
                </c:pt>
                <c:pt idx="2">
                  <c:v>28.81666666666667</c:v>
                </c:pt>
                <c:pt idx="3">
                  <c:v>21.75333333333332</c:v>
                </c:pt>
                <c:pt idx="4">
                  <c:v>18.8386935720327</c:v>
                </c:pt>
                <c:pt idx="5">
                  <c:v>30.251585693296001</c:v>
                </c:pt>
                <c:pt idx="6">
                  <c:v>29.021911630530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B65-42F6-864C-5EDF9C6408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4535656"/>
        <c:axId val="414533304"/>
        <c:extLst xmlns:c16r2="http://schemas.microsoft.com/office/drawing/2015/06/chart">
          <c:ext xmlns:c15="http://schemas.microsoft.com/office/drawing/2012/chart" uri="{02D57815-91ED-43cb-92C2-25804820EDAC}">
            <c15:filteredScatterSeries>
              <c15:ser>
                <c:idx val="1"/>
                <c:order val="1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'Clinical samples Cp'!$C$3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accent2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9050" cap="rnd">
                      <a:noFill/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Clinical samples Cp'!$A$50:$A$5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28.63</c:v>
                      </c:pt>
                      <c:pt idx="1">
                        <c:v>21.64</c:v>
                      </c:pt>
                      <c:pt idx="2">
                        <c:v>27.67</c:v>
                      </c:pt>
                      <c:pt idx="3">
                        <c:v>21.33</c:v>
                      </c:pt>
                      <c:pt idx="4">
                        <c:v>18</c:v>
                      </c:pt>
                      <c:pt idx="5">
                        <c:v>29.74</c:v>
                      </c:pt>
                      <c:pt idx="6">
                        <c:v>28.68</c:v>
                      </c:pt>
                    </c:numCache>
                  </c:numRef>
                </c:xVal>
                <c:y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Clinical samples Cp'!$C$50:$C$5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30.661636436553998</c:v>
                      </c:pt>
                      <c:pt idx="1">
                        <c:v>23.7338587631175</c:v>
                      </c:pt>
                      <c:pt idx="2">
                        <c:v>30.1</c:v>
                      </c:pt>
                      <c:pt idx="3">
                        <c:v>23.38</c:v>
                      </c:pt>
                      <c:pt idx="4">
                        <c:v>20.809093022061248</c:v>
                      </c:pt>
                      <c:pt idx="5">
                        <c:v>31.2976414341822</c:v>
                      </c:pt>
                      <c:pt idx="6">
                        <c:v>30.246958724643449</c:v>
                      </c:pt>
                    </c:numCache>
                  </c:numRef>
                </c:yVal>
                <c:smooth val="0"/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1-0B65-42F6-864C-5EDF9C6408B3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linical samples Cp'!$D$3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9050" cap="rnd">
                      <a:noFill/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linical samples Cp'!$A$50:$A$5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28.63</c:v>
                      </c:pt>
                      <c:pt idx="1">
                        <c:v>21.64</c:v>
                      </c:pt>
                      <c:pt idx="2">
                        <c:v>27.67</c:v>
                      </c:pt>
                      <c:pt idx="3">
                        <c:v>21.33</c:v>
                      </c:pt>
                      <c:pt idx="4">
                        <c:v>18</c:v>
                      </c:pt>
                      <c:pt idx="5">
                        <c:v>29.74</c:v>
                      </c:pt>
                      <c:pt idx="6">
                        <c:v>28.68</c:v>
                      </c:pt>
                    </c:numCache>
                  </c:numRef>
                </c:xVal>
                <c:yVal>
                  <c:num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linical samples Cp'!$D$50:$D$5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30.194756923439499</c:v>
                      </c:pt>
                      <c:pt idx="1">
                        <c:v>23.1754284089916</c:v>
                      </c:pt>
                      <c:pt idx="2">
                        <c:v>30.806666666666668</c:v>
                      </c:pt>
                      <c:pt idx="3">
                        <c:v>22.483333333333331</c:v>
                      </c:pt>
                      <c:pt idx="4">
                        <c:v>19.83962504841935</c:v>
                      </c:pt>
                      <c:pt idx="5">
                        <c:v>31.539808222490251</c:v>
                      </c:pt>
                      <c:pt idx="6">
                        <c:v>31.888735088726502</c:v>
                      </c:pt>
                    </c:numCache>
                  </c:numRef>
                </c:yVal>
                <c:smooth val="0"/>
                <c:extLst xmlns:c16r2="http://schemas.microsoft.com/office/drawing/2015/06/chart" xmlns:c15="http://schemas.microsoft.com/office/drawing/2012/chart">
                  <c:ext xmlns:c16="http://schemas.microsoft.com/office/drawing/2014/chart" uri="{C3380CC4-5D6E-409C-BE32-E72D297353CC}">
                    <c16:uniqueId val="{00000002-0B65-42F6-864C-5EDF9C6408B3}"/>
                  </c:ext>
                </c:extLst>
              </c15:ser>
            </c15:filteredScatterSeries>
          </c:ext>
        </c:extLst>
      </c:scatterChart>
      <c:valAx>
        <c:axId val="414535656"/>
        <c:scaling>
          <c:orientation val="minMax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dirty="0"/>
                  <a:t>SH N1 SYBR primer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0.21100117419533099"/>
              <c:y val="0.8911705115807889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533304"/>
        <c:crosses val="autoZero"/>
        <c:crossBetween val="midCat"/>
        <c:majorUnit val="5"/>
      </c:valAx>
      <c:valAx>
        <c:axId val="414533304"/>
        <c:scaling>
          <c:orientation val="minMax"/>
          <c:min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dirty="0"/>
                  <a:t>BGI </a:t>
                </a:r>
                <a:r>
                  <a:rPr lang="en-US" sz="900" dirty="0" err="1"/>
                  <a:t>Taqman</a:t>
                </a:r>
                <a:r>
                  <a:rPr lang="en-US" sz="900" dirty="0"/>
                  <a:t> Probe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535656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975848325006099"/>
          <c:y val="5.7938125133007001E-2"/>
          <c:w val="0.67380285757008596"/>
          <c:h val="0.726251323847676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Clinical samples Cp'!$B$37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rgbClr val="00B050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28741970860097"/>
                  <c:y val="0.3857255557102419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Clinical samples Cp'!$A$38:$A$44</c:f>
              <c:numCache>
                <c:formatCode>General</c:formatCode>
                <c:ptCount val="7"/>
                <c:pt idx="0">
                  <c:v>30.22</c:v>
                </c:pt>
                <c:pt idx="1">
                  <c:v>22.65</c:v>
                </c:pt>
                <c:pt idx="2">
                  <c:v>29.47</c:v>
                </c:pt>
                <c:pt idx="3">
                  <c:v>22.12</c:v>
                </c:pt>
                <c:pt idx="4">
                  <c:v>18.649999999999999</c:v>
                </c:pt>
                <c:pt idx="5">
                  <c:v>31.59</c:v>
                </c:pt>
                <c:pt idx="6">
                  <c:v>30.58</c:v>
                </c:pt>
              </c:numCache>
            </c:numRef>
          </c:xVal>
          <c:yVal>
            <c:numRef>
              <c:f>'Clinical samples Cp'!$B$38:$B$44</c:f>
              <c:numCache>
                <c:formatCode>General</c:formatCode>
                <c:ptCount val="7"/>
                <c:pt idx="0">
                  <c:v>29.244075507508651</c:v>
                </c:pt>
                <c:pt idx="1">
                  <c:v>22.3087603134672</c:v>
                </c:pt>
                <c:pt idx="2">
                  <c:v>28.81666666666667</c:v>
                </c:pt>
                <c:pt idx="3">
                  <c:v>21.75333333333332</c:v>
                </c:pt>
                <c:pt idx="4">
                  <c:v>18.8386935720327</c:v>
                </c:pt>
                <c:pt idx="5">
                  <c:v>30.251585693296001</c:v>
                </c:pt>
                <c:pt idx="6">
                  <c:v>29.021911630530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A91-4AD4-884C-626F91856A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4534480"/>
        <c:axId val="414534872"/>
        <c:extLst xmlns:c16r2="http://schemas.microsoft.com/office/drawing/2015/06/chart">
          <c:ext xmlns:c15="http://schemas.microsoft.com/office/drawing/2012/chart" uri="{02D57815-91ED-43cb-92C2-25804820EDAC}">
            <c15:filteredScatterSeries>
              <c15:ser>
                <c:idx val="1"/>
                <c:order val="1"/>
                <c:tx>
                  <c:strRef>
                    <c:extLst xmlns:c16r2="http://schemas.microsoft.com/office/drawing/2015/06/chart">
                      <c:ext uri="{02D57815-91ED-43cb-92C2-25804820EDAC}">
                        <c15:formulaRef>
                          <c15:sqref>'Clinical samples Cp'!$C$3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accent2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9050" cap="rnd">
                      <a:noFill/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Clinical samples Cp'!$A$38:$A$44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30.22</c:v>
                      </c:pt>
                      <c:pt idx="1">
                        <c:v>22.65</c:v>
                      </c:pt>
                      <c:pt idx="2">
                        <c:v>29.47</c:v>
                      </c:pt>
                      <c:pt idx="3">
                        <c:v>22.12</c:v>
                      </c:pt>
                      <c:pt idx="4">
                        <c:v>18.649999999999999</c:v>
                      </c:pt>
                      <c:pt idx="5">
                        <c:v>31.59</c:v>
                      </c:pt>
                      <c:pt idx="6">
                        <c:v>30.58</c:v>
                      </c:pt>
                    </c:numCache>
                  </c:numRef>
                </c:xVal>
                <c:yVal>
                  <c:numRef>
                    <c:extLst xmlns:c16r2="http://schemas.microsoft.com/office/drawing/2015/06/chart">
                      <c:ext uri="{02D57815-91ED-43cb-92C2-25804820EDAC}">
                        <c15:formulaRef>
                          <c15:sqref>'Clinical samples Cp'!$C$38:$C$44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30.661636436553998</c:v>
                      </c:pt>
                      <c:pt idx="1">
                        <c:v>23.7338587631175</c:v>
                      </c:pt>
                      <c:pt idx="2">
                        <c:v>30.1</c:v>
                      </c:pt>
                      <c:pt idx="3">
                        <c:v>23.38</c:v>
                      </c:pt>
                      <c:pt idx="4">
                        <c:v>20.809093022061248</c:v>
                      </c:pt>
                      <c:pt idx="5">
                        <c:v>31.2976414341822</c:v>
                      </c:pt>
                      <c:pt idx="6">
                        <c:v>30.246958724643449</c:v>
                      </c:pt>
                    </c:numCache>
                  </c:numRef>
                </c:yVal>
                <c:smooth val="0"/>
                <c:extLst xmlns:c16r2="http://schemas.microsoft.com/office/drawing/2015/06/chart">
                  <c:ext xmlns:c16="http://schemas.microsoft.com/office/drawing/2014/chart" uri="{C3380CC4-5D6E-409C-BE32-E72D297353CC}">
                    <c16:uniqueId val="{00000001-3A91-4AD4-884C-626F91856ACD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linical samples Cp'!$D$3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9050" cap="rnd">
                      <a:noFill/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linical samples Cp'!$A$38:$A$44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30.22</c:v>
                      </c:pt>
                      <c:pt idx="1">
                        <c:v>22.65</c:v>
                      </c:pt>
                      <c:pt idx="2">
                        <c:v>29.47</c:v>
                      </c:pt>
                      <c:pt idx="3">
                        <c:v>22.12</c:v>
                      </c:pt>
                      <c:pt idx="4">
                        <c:v>18.649999999999999</c:v>
                      </c:pt>
                      <c:pt idx="5">
                        <c:v>31.59</c:v>
                      </c:pt>
                      <c:pt idx="6">
                        <c:v>30.58</c:v>
                      </c:pt>
                    </c:numCache>
                  </c:numRef>
                </c:xVal>
                <c:yVal>
                  <c:numRef>
                    <c:extLst xmlns:c16r2="http://schemas.microsoft.com/office/drawing/2015/06/chart"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linical samples Cp'!$D$38:$D$44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30.194756923439499</c:v>
                      </c:pt>
                      <c:pt idx="1">
                        <c:v>23.1754284089916</c:v>
                      </c:pt>
                      <c:pt idx="2">
                        <c:v>30.806666666666668</c:v>
                      </c:pt>
                      <c:pt idx="3">
                        <c:v>22.483333333333331</c:v>
                      </c:pt>
                      <c:pt idx="4">
                        <c:v>19.83962504841935</c:v>
                      </c:pt>
                      <c:pt idx="5">
                        <c:v>31.539808222490251</c:v>
                      </c:pt>
                      <c:pt idx="6">
                        <c:v>31.888735088726502</c:v>
                      </c:pt>
                    </c:numCache>
                  </c:numRef>
                </c:yVal>
                <c:smooth val="0"/>
                <c:extLst xmlns:c16r2="http://schemas.microsoft.com/office/drawing/2015/06/chart" xmlns:c15="http://schemas.microsoft.com/office/drawing/2012/chart">
                  <c:ext xmlns:c16="http://schemas.microsoft.com/office/drawing/2014/chart" uri="{C3380CC4-5D6E-409C-BE32-E72D297353CC}">
                    <c16:uniqueId val="{00000002-3A91-4AD4-884C-626F91856ACD}"/>
                  </c:ext>
                </c:extLst>
              </c15:ser>
            </c15:filteredScatterSeries>
          </c:ext>
        </c:extLst>
      </c:scatterChart>
      <c:valAx>
        <c:axId val="414534480"/>
        <c:scaling>
          <c:orientation val="minMax"/>
          <c:min val="1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dirty="0"/>
                  <a:t>S1 SYBR green primer (</a:t>
                </a:r>
                <a:r>
                  <a:rPr lang="en-US" sz="900" dirty="0" smtClean="0"/>
                  <a:t>Ct)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0.14551719337324201"/>
              <c:y val="0.88552575267736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534872"/>
        <c:crosses val="autoZero"/>
        <c:crossBetween val="midCat"/>
        <c:majorUnit val="5"/>
      </c:valAx>
      <c:valAx>
        <c:axId val="414534872"/>
        <c:scaling>
          <c:orientation val="minMax"/>
          <c:min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dirty="0"/>
                  <a:t>BGI </a:t>
                </a:r>
                <a:r>
                  <a:rPr lang="en-US" sz="900" dirty="0" err="1"/>
                  <a:t>Taqman</a:t>
                </a:r>
                <a:r>
                  <a:rPr lang="en-US" sz="900" dirty="0"/>
                  <a:t> Probe (</a:t>
                </a:r>
                <a:r>
                  <a:rPr lang="en-US" sz="900" dirty="0" smtClean="0"/>
                  <a:t>Ct) </a:t>
                </a:r>
                <a:endParaRPr lang="en-US" sz="9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4534480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1894</cdr:x>
      <cdr:y>0.15236</cdr:y>
    </cdr:from>
    <cdr:to>
      <cdr:x>0.8197</cdr:x>
      <cdr:y>0.26194</cdr:y>
    </cdr:to>
    <cdr:cxnSp macro="">
      <cdr:nvCxnSpPr>
        <cdr:cNvPr id="3" name="Straight Connector 2"/>
        <cdr:cNvCxnSpPr/>
      </cdr:nvCxnSpPr>
      <cdr:spPr>
        <a:xfrm xmlns:a="http://schemas.openxmlformats.org/drawingml/2006/main" flipH="1">
          <a:off x="2673350" y="317645"/>
          <a:ext cx="2485" cy="228455"/>
        </a:xfrm>
        <a:prstGeom xmlns:a="http://schemas.openxmlformats.org/drawingml/2006/main" prst="line">
          <a:avLst/>
        </a:prstGeom>
        <a:ln xmlns:a="http://schemas.openxmlformats.org/drawingml/2006/main" w="19050" cmpd="sng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8879</cdr:x>
      <cdr:y>0.14807</cdr:y>
    </cdr:from>
    <cdr:to>
      <cdr:x>0.82527</cdr:x>
      <cdr:y>0.26743</cdr:y>
    </cdr:to>
    <cdr:sp macro="" textlink="">
      <cdr:nvSpPr>
        <cdr:cNvPr id="6" name="TextBox 2"/>
        <cdr:cNvSpPr txBox="1"/>
      </cdr:nvSpPr>
      <cdr:spPr>
        <a:xfrm xmlns:a="http://schemas.openxmlformats.org/drawingml/2006/main">
          <a:off x="2248504" y="308701"/>
          <a:ext cx="445507" cy="248851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/>
            <a:t>SYBR</a:t>
          </a:r>
        </a:p>
      </cdr:txBody>
    </cdr:sp>
  </cdr:relSizeAnchor>
  <cdr:relSizeAnchor xmlns:cdr="http://schemas.openxmlformats.org/drawingml/2006/chartDrawing">
    <cdr:from>
      <cdr:x>0.67866</cdr:x>
      <cdr:y>0.2472</cdr:y>
    </cdr:from>
    <cdr:to>
      <cdr:x>0.83012</cdr:x>
      <cdr:y>0.36656</cdr:y>
    </cdr:to>
    <cdr:sp macro="" textlink="">
      <cdr:nvSpPr>
        <cdr:cNvPr id="7" name="TextBox 3"/>
        <cdr:cNvSpPr txBox="1"/>
      </cdr:nvSpPr>
      <cdr:spPr>
        <a:xfrm xmlns:a="http://schemas.openxmlformats.org/drawingml/2006/main">
          <a:off x="2215435" y="515366"/>
          <a:ext cx="494431" cy="248851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/>
            <a:t>Probe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4719" cy="465614"/>
          </a:xfrm>
          <a:prstGeom prst="rect">
            <a:avLst/>
          </a:prstGeom>
        </p:spPr>
        <p:txBody>
          <a:bodyPr vert="horz" lIns="93355" tIns="46678" rIns="93355" bIns="46678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9930" y="0"/>
            <a:ext cx="3044719" cy="465614"/>
          </a:xfrm>
          <a:prstGeom prst="rect">
            <a:avLst/>
          </a:prstGeom>
        </p:spPr>
        <p:txBody>
          <a:bodyPr vert="horz" lIns="93355" tIns="46678" rIns="93355" bIns="46678" rtlCol="0"/>
          <a:lstStyle>
            <a:lvl1pPr algn="r">
              <a:defRPr sz="1300"/>
            </a:lvl1pPr>
          </a:lstStyle>
          <a:p>
            <a:fld id="{2926EDC0-61BF-4C6E-ADE7-AAF87D8619AE}" type="datetimeFigureOut">
              <a:rPr lang="en-US" smtClean="0"/>
              <a:t>5/1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3450" y="698500"/>
            <a:ext cx="261937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55" tIns="46678" rIns="93355" bIns="4667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628" y="4423331"/>
            <a:ext cx="5621020" cy="4190524"/>
          </a:xfrm>
          <a:prstGeom prst="rect">
            <a:avLst/>
          </a:prstGeom>
        </p:spPr>
        <p:txBody>
          <a:bodyPr vert="horz" lIns="93355" tIns="46678" rIns="93355" bIns="46678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5045"/>
            <a:ext cx="3044719" cy="465614"/>
          </a:xfrm>
          <a:prstGeom prst="rect">
            <a:avLst/>
          </a:prstGeom>
        </p:spPr>
        <p:txBody>
          <a:bodyPr vert="horz" lIns="93355" tIns="46678" rIns="93355" bIns="46678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9930" y="8845045"/>
            <a:ext cx="3044719" cy="465614"/>
          </a:xfrm>
          <a:prstGeom prst="rect">
            <a:avLst/>
          </a:prstGeom>
        </p:spPr>
        <p:txBody>
          <a:bodyPr vert="horz" lIns="93355" tIns="46678" rIns="93355" bIns="46678" rtlCol="0" anchor="b"/>
          <a:lstStyle>
            <a:lvl1pPr algn="r">
              <a:defRPr sz="1300"/>
            </a:lvl1pPr>
          </a:lstStyle>
          <a:p>
            <a:fld id="{351D21A0-C4AC-42CD-BD72-E051F0AA4F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0213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1D21A0-C4AC-42CD-BD72-E051F0AA4F7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170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C6F9-CC28-4B34-A692-37E9DC829894}" type="datetime1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886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B997C-D1EF-47AE-B4CC-29B7D799CED0}" type="datetime1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197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221773-9C5F-4D53-BC1E-F1F81C6FE5C2}" type="datetime1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197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22B88-873B-466E-B75E-520BBEBF2C51}" type="datetime1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506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4989E-C257-4C6D-9111-B15E866CF6DD}" type="datetime1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133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BBE2FE-31FC-44F1-B3EC-2ECA717B9F57}" type="datetime1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98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A3365-D82E-43BB-95CD-9D2F84D42F57}" type="datetime1">
              <a:rPr lang="en-US" smtClean="0"/>
              <a:t>5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860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5D77F-C7C6-4152-B29A-414BE54CE335}" type="datetime1">
              <a:rPr lang="en-US" smtClean="0"/>
              <a:t>5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152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74B81-137D-4EC0-BF42-B8CFD4D4E380}" type="datetime1">
              <a:rPr lang="en-US" smtClean="0"/>
              <a:t>5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945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E47BD-745E-4A3C-9648-72E63D5C55C3}" type="datetime1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021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255C5-E16C-467E-8DDF-28BE5BE92CDA}" type="datetime1">
              <a:rPr lang="en-US" smtClean="0"/>
              <a:t>5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970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6A2A5-E0D5-4F92-86AB-FCACC73173F5}" type="datetime1">
              <a:rPr lang="en-US" smtClean="0"/>
              <a:t>5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12185-DE76-4E28-94B2-BD2CD19D4D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013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9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8.emf"/><Relationship Id="rId5" Type="http://schemas.openxmlformats.org/officeDocument/2006/relationships/image" Target="../media/image3.emf"/><Relationship Id="rId15" Type="http://schemas.openxmlformats.org/officeDocument/2006/relationships/chart" Target="../charts/chart4.xml"/><Relationship Id="rId10" Type="http://schemas.openxmlformats.org/officeDocument/2006/relationships/chart" Target="../charts/chart1.xml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chart" Target="../charts/chart6.xml"/><Relationship Id="rId7" Type="http://schemas.openxmlformats.org/officeDocument/2006/relationships/image" Target="../media/image13.png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chart" Target="../charts/chart7.xml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06898" y="2819400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41923" y="7162800"/>
            <a:ext cx="2487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F</a:t>
            </a:r>
            <a:endParaRPr lang="en-US" sz="110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764732" y="2880586"/>
            <a:ext cx="941789" cy="1481587"/>
            <a:chOff x="777241" y="3281343"/>
            <a:chExt cx="941789" cy="1481587"/>
          </a:xfrm>
        </p:grpSpPr>
        <p:pic>
          <p:nvPicPr>
            <p:cNvPr id="1026" name="Picture 2"/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99" b="13536"/>
            <a:stretch/>
          </p:blipFill>
          <p:spPr bwMode="auto">
            <a:xfrm>
              <a:off x="1094960" y="3281343"/>
              <a:ext cx="624070" cy="11735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4" name="TextBox 93"/>
            <p:cNvSpPr txBox="1"/>
            <p:nvPr/>
          </p:nvSpPr>
          <p:spPr>
            <a:xfrm>
              <a:off x="1046292" y="3389000"/>
              <a:ext cx="5661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 &lt; 0.001</a:t>
              </a:r>
              <a:endParaRPr lang="en-US" sz="800" dirty="0"/>
            </a:p>
          </p:txBody>
        </p:sp>
        <p:sp>
          <p:nvSpPr>
            <p:cNvPr id="95" name="TextBox 94"/>
            <p:cNvSpPr txBox="1"/>
            <p:nvPr/>
          </p:nvSpPr>
          <p:spPr>
            <a:xfrm rot="16200000">
              <a:off x="442854" y="3793458"/>
              <a:ext cx="8996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Expression (Ct)</a:t>
              </a:r>
              <a:endParaRPr lang="en-US" sz="900" b="1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894767" y="331720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5</a:t>
              </a:r>
              <a:endParaRPr lang="en-US" sz="8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894767" y="356054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0</a:t>
              </a:r>
              <a:endParaRPr lang="en-US" sz="80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894767" y="381802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5</a:t>
              </a:r>
              <a:endParaRPr lang="en-US" sz="8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894767" y="405696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0</a:t>
              </a:r>
              <a:endParaRPr lang="en-US" sz="80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894767" y="429976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</a:t>
              </a:r>
              <a:r>
                <a:rPr lang="en-US" sz="800" dirty="0" smtClean="0"/>
                <a:t>5</a:t>
              </a:r>
              <a:endParaRPr lang="en-US" sz="800" dirty="0"/>
            </a:p>
          </p:txBody>
        </p:sp>
        <p:sp>
          <p:nvSpPr>
            <p:cNvPr id="102" name="TextBox 101"/>
            <p:cNvSpPr txBox="1"/>
            <p:nvPr/>
          </p:nvSpPr>
          <p:spPr>
            <a:xfrm rot="18900000">
              <a:off x="797148" y="4532098"/>
              <a:ext cx="6896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/>
                <a:t>Norgen</a:t>
              </a:r>
              <a:r>
                <a:rPr lang="en-US" sz="900" dirty="0" smtClean="0"/>
                <a:t> N1</a:t>
              </a:r>
              <a:endParaRPr lang="en-US" sz="900" dirty="0"/>
            </a:p>
          </p:txBody>
        </p:sp>
        <p:sp>
          <p:nvSpPr>
            <p:cNvPr id="103" name="TextBox 102"/>
            <p:cNvSpPr txBox="1"/>
            <p:nvPr/>
          </p:nvSpPr>
          <p:spPr>
            <a:xfrm rot="18900000">
              <a:off x="1248814" y="4423988"/>
              <a:ext cx="34817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BGI</a:t>
              </a:r>
              <a:endParaRPr lang="en-US" sz="900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533458" y="2922586"/>
            <a:ext cx="1781866" cy="1563069"/>
            <a:chOff x="4535905" y="3403116"/>
            <a:chExt cx="1781866" cy="1563069"/>
          </a:xfrm>
        </p:grpSpPr>
        <p:sp>
          <p:nvSpPr>
            <p:cNvPr id="41" name="TextBox 40"/>
            <p:cNvSpPr txBox="1"/>
            <p:nvPr/>
          </p:nvSpPr>
          <p:spPr>
            <a:xfrm>
              <a:off x="4762204" y="3403116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GI kit</a:t>
              </a:r>
              <a:endParaRPr lang="en-US" sz="800" dirty="0"/>
            </a:p>
          </p:txBody>
        </p:sp>
        <p:sp>
          <p:nvSpPr>
            <p:cNvPr id="123" name="TextBox 122"/>
            <p:cNvSpPr txBox="1"/>
            <p:nvPr/>
          </p:nvSpPr>
          <p:spPr>
            <a:xfrm rot="16200000">
              <a:off x="4407985" y="3765878"/>
              <a:ext cx="527709" cy="271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700"/>
                </a:lnSpc>
              </a:pPr>
              <a:r>
                <a:rPr lang="en-US" sz="800" dirty="0" smtClean="0"/>
                <a:t> Clinical </a:t>
              </a:r>
            </a:p>
            <a:p>
              <a:pPr algn="ctr">
                <a:lnSpc>
                  <a:spcPts val="700"/>
                </a:lnSpc>
              </a:pPr>
              <a:r>
                <a:rPr lang="en-US" sz="800" dirty="0" smtClean="0"/>
                <a:t>(</a:t>
              </a:r>
              <a:r>
                <a:rPr lang="en-US" sz="800" dirty="0" err="1" smtClean="0"/>
                <a:t>RdRp</a:t>
              </a:r>
              <a:r>
                <a:rPr lang="en-US" sz="800" dirty="0" smtClean="0"/>
                <a:t>)</a:t>
              </a:r>
              <a:endParaRPr lang="en-US" sz="800" dirty="0"/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4404716" y="4289476"/>
              <a:ext cx="538929" cy="276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700"/>
                </a:lnSpc>
              </a:pPr>
              <a:r>
                <a:rPr lang="en-US" sz="800" dirty="0" smtClean="0"/>
                <a:t> Clinical </a:t>
              </a:r>
            </a:p>
            <a:p>
              <a:pPr algn="ctr">
                <a:lnSpc>
                  <a:spcPts val="700"/>
                </a:lnSpc>
              </a:pPr>
              <a:r>
                <a:rPr lang="en-US" sz="800" dirty="0" smtClean="0"/>
                <a:t>(N gene)</a:t>
              </a:r>
              <a:endParaRPr lang="en-US" sz="800" dirty="0"/>
            </a:p>
          </p:txBody>
        </p:sp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7240" y="3553315"/>
              <a:ext cx="553821" cy="6885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7240" y="4102083"/>
              <a:ext cx="553821" cy="6885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5" name="TextBox 54"/>
            <p:cNvSpPr txBox="1"/>
            <p:nvPr/>
          </p:nvSpPr>
          <p:spPr>
            <a:xfrm rot="17100000">
              <a:off x="4789841" y="467925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BGI</a:t>
              </a:r>
              <a:endParaRPr lang="en-US" sz="800" dirty="0"/>
            </a:p>
          </p:txBody>
        </p:sp>
        <p:sp>
          <p:nvSpPr>
            <p:cNvPr id="126" name="TextBox 125"/>
            <p:cNvSpPr txBox="1"/>
            <p:nvPr/>
          </p:nvSpPr>
          <p:spPr>
            <a:xfrm rot="17100000">
              <a:off x="4870019" y="467475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Clin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4824668" y="3539170"/>
              <a:ext cx="4331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 = 0.96</a:t>
              </a:r>
              <a:endParaRPr lang="en-US" sz="600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823652" y="4148770"/>
              <a:ext cx="4331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 = 0.69</a:t>
              </a:r>
              <a:endParaRPr lang="en-US" sz="600" dirty="0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5173940" y="3403116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orgen</a:t>
              </a:r>
              <a:r>
                <a:rPr lang="en-US" sz="800" dirty="0" smtClean="0"/>
                <a:t> N1</a:t>
              </a:r>
              <a:endParaRPr lang="en-US" sz="800" dirty="0"/>
            </a:p>
          </p:txBody>
        </p:sp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6199" y="3553315"/>
              <a:ext cx="553821" cy="6885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6199" y="4102083"/>
              <a:ext cx="553821" cy="6885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0" name="TextBox 129"/>
            <p:cNvSpPr txBox="1"/>
            <p:nvPr/>
          </p:nvSpPr>
          <p:spPr>
            <a:xfrm rot="17100000">
              <a:off x="5303679" y="4661580"/>
              <a:ext cx="301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N1</a:t>
              </a:r>
              <a:endParaRPr lang="en-US" sz="800" dirty="0"/>
            </a:p>
          </p:txBody>
        </p:sp>
        <p:sp>
          <p:nvSpPr>
            <p:cNvPr id="131" name="TextBox 130"/>
            <p:cNvSpPr txBox="1"/>
            <p:nvPr/>
          </p:nvSpPr>
          <p:spPr>
            <a:xfrm rot="17100000">
              <a:off x="5364970" y="467475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Clin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5335016" y="3539170"/>
              <a:ext cx="4331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 = 0.32</a:t>
              </a:r>
              <a:endParaRPr lang="en-US" sz="600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5334000" y="4148770"/>
              <a:ext cx="4331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 = 0.02</a:t>
              </a:r>
              <a:endParaRPr lang="en-US" sz="600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5684264" y="3403116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orgen</a:t>
              </a:r>
              <a:r>
                <a:rPr lang="en-US" sz="800" dirty="0" smtClean="0"/>
                <a:t> N2</a:t>
              </a:r>
              <a:endParaRPr lang="en-US" sz="800" dirty="0"/>
            </a:p>
          </p:txBody>
        </p:sp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63950" y="3553315"/>
              <a:ext cx="553821" cy="6885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63950" y="4102083"/>
              <a:ext cx="553821" cy="6885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9" name="TextBox 138"/>
            <p:cNvSpPr txBox="1"/>
            <p:nvPr/>
          </p:nvSpPr>
          <p:spPr>
            <a:xfrm rot="17100000">
              <a:off x="5814667" y="4656398"/>
              <a:ext cx="3016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N2</a:t>
              </a:r>
              <a:endParaRPr lang="en-US" sz="800" dirty="0"/>
            </a:p>
          </p:txBody>
        </p:sp>
        <p:sp>
          <p:nvSpPr>
            <p:cNvPr id="140" name="TextBox 139"/>
            <p:cNvSpPr txBox="1"/>
            <p:nvPr/>
          </p:nvSpPr>
          <p:spPr>
            <a:xfrm rot="17100000">
              <a:off x="5875958" y="4674759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Clin</a:t>
              </a:r>
              <a:r>
                <a:rPr lang="en-US" sz="800" dirty="0" smtClean="0"/>
                <a:t>.</a:t>
              </a:r>
              <a:endParaRPr lang="en-US" sz="800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5830636" y="3539170"/>
              <a:ext cx="4331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 = 0.33</a:t>
              </a:r>
              <a:endParaRPr lang="en-US" sz="600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829620" y="4148770"/>
              <a:ext cx="4331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 = 0.02</a:t>
              </a:r>
              <a:endParaRPr lang="en-US" sz="600" dirty="0"/>
            </a:p>
          </p:txBody>
        </p:sp>
      </p:grpSp>
      <p:graphicFrame>
        <p:nvGraphicFramePr>
          <p:cNvPr id="135" name="Chart 1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204910"/>
              </p:ext>
            </p:extLst>
          </p:nvPr>
        </p:nvGraphicFramePr>
        <p:xfrm>
          <a:off x="707633" y="7162800"/>
          <a:ext cx="2045758" cy="1724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4" name="Slide Number Placeholder 2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1</a:t>
            </a:fld>
            <a:endParaRPr lang="en-US"/>
          </a:p>
        </p:txBody>
      </p:sp>
      <p:sp>
        <p:nvSpPr>
          <p:cNvPr id="137" name="TextBox 136"/>
          <p:cNvSpPr txBox="1"/>
          <p:nvPr/>
        </p:nvSpPr>
        <p:spPr>
          <a:xfrm>
            <a:off x="304800" y="228600"/>
            <a:ext cx="6553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 S1. BGI </a:t>
            </a:r>
            <a:r>
              <a:rPr lang="en-US" sz="1400" b="1" dirty="0"/>
              <a:t>detection kit shows enhanced sensitivity over </a:t>
            </a:r>
            <a:r>
              <a:rPr lang="en-US" sz="1400" b="1" dirty="0" err="1"/>
              <a:t>Norgen</a:t>
            </a:r>
            <a:r>
              <a:rPr lang="en-US" sz="1400" b="1" dirty="0"/>
              <a:t> kit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8" name="Group 137"/>
          <p:cNvGrpSpPr/>
          <p:nvPr/>
        </p:nvGrpSpPr>
        <p:grpSpPr>
          <a:xfrm>
            <a:off x="3090193" y="2938814"/>
            <a:ext cx="1504426" cy="1576220"/>
            <a:chOff x="4509718" y="3426364"/>
            <a:chExt cx="1504426" cy="1576220"/>
          </a:xfrm>
        </p:grpSpPr>
        <p:pic>
          <p:nvPicPr>
            <p:cNvPr id="144" name="Picture 7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2000" y="3426364"/>
              <a:ext cx="1428212" cy="12615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5" name="TextBox 144"/>
            <p:cNvSpPr txBox="1"/>
            <p:nvPr/>
          </p:nvSpPr>
          <p:spPr>
            <a:xfrm>
              <a:off x="4895749" y="4570799"/>
              <a:ext cx="8851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/>
                <a:t>Norgen</a:t>
              </a:r>
              <a:r>
                <a:rPr lang="en-US" sz="900" dirty="0" smtClean="0"/>
                <a:t> N2 (Ct)</a:t>
              </a:r>
              <a:endParaRPr lang="en-US" sz="900" dirty="0"/>
            </a:p>
          </p:txBody>
        </p:sp>
        <p:sp>
          <p:nvSpPr>
            <p:cNvPr id="146" name="TextBox 145"/>
            <p:cNvSpPr txBox="1"/>
            <p:nvPr/>
          </p:nvSpPr>
          <p:spPr>
            <a:xfrm rot="16200000">
              <a:off x="4244411" y="3988023"/>
              <a:ext cx="718719" cy="188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Clinical lab (Ct)</a:t>
              </a:r>
              <a:endParaRPr lang="en-US" sz="900" dirty="0"/>
            </a:p>
          </p:txBody>
        </p:sp>
        <p:grpSp>
          <p:nvGrpSpPr>
            <p:cNvPr id="147" name="Group 146"/>
            <p:cNvGrpSpPr/>
            <p:nvPr/>
          </p:nvGrpSpPr>
          <p:grpSpPr>
            <a:xfrm>
              <a:off x="4644858" y="4715245"/>
              <a:ext cx="1369286" cy="287339"/>
              <a:chOff x="3348832" y="3417916"/>
              <a:chExt cx="1369286" cy="287339"/>
            </a:xfrm>
          </p:grpSpPr>
          <p:sp>
            <p:nvSpPr>
              <p:cNvPr id="148" name="TextBox 147"/>
              <p:cNvSpPr txBox="1"/>
              <p:nvPr/>
            </p:nvSpPr>
            <p:spPr>
              <a:xfrm>
                <a:off x="3348832" y="3417916"/>
                <a:ext cx="125707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 smtClean="0"/>
                  <a:t>RdRp</a:t>
                </a:r>
                <a:r>
                  <a:rPr lang="en-US" sz="700" dirty="0" smtClean="0"/>
                  <a:t> (R</a:t>
                </a:r>
                <a:r>
                  <a:rPr lang="en-US" sz="700" baseline="30000" dirty="0" smtClean="0"/>
                  <a:t>2</a:t>
                </a:r>
                <a:r>
                  <a:rPr lang="en-US" sz="700" dirty="0" smtClean="0"/>
                  <a:t> = 0.79, slope: 1.297)</a:t>
                </a:r>
                <a:endParaRPr lang="en-US" sz="700" dirty="0"/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3348832" y="3505200"/>
                <a:ext cx="13692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/>
                  <a:t>N</a:t>
                </a:r>
                <a:r>
                  <a:rPr lang="en-US" sz="700" dirty="0" smtClean="0"/>
                  <a:t> gene (R</a:t>
                </a:r>
                <a:r>
                  <a:rPr lang="en-US" sz="700" baseline="30000" dirty="0" smtClean="0"/>
                  <a:t>2</a:t>
                </a:r>
                <a:r>
                  <a:rPr lang="en-US" sz="700" dirty="0" smtClean="0"/>
                  <a:t> = 0.91, slope: 0.973)</a:t>
                </a:r>
                <a:endParaRPr lang="en-US" sz="700" dirty="0"/>
              </a:p>
            </p:txBody>
          </p:sp>
          <p:sp>
            <p:nvSpPr>
              <p:cNvPr id="150" name="Oval 149"/>
              <p:cNvSpPr/>
              <p:nvPr/>
            </p:nvSpPr>
            <p:spPr>
              <a:xfrm>
                <a:off x="3370104" y="3580828"/>
                <a:ext cx="45720" cy="45719"/>
              </a:xfrm>
              <a:prstGeom prst="ellipse">
                <a:avLst/>
              </a:prstGeom>
              <a:noFill/>
              <a:ln w="1270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51" name="Rectangle 150"/>
              <p:cNvSpPr/>
              <p:nvPr/>
            </p:nvSpPr>
            <p:spPr>
              <a:xfrm>
                <a:off x="3370104" y="3501243"/>
                <a:ext cx="45719" cy="45719"/>
              </a:xfrm>
              <a:prstGeom prst="rect">
                <a:avLst/>
              </a:prstGeom>
              <a:noFill/>
              <a:ln w="12700">
                <a:solidFill>
                  <a:srgbClr val="1403F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</p:grpSp>
      </p:grpSp>
      <p:grpSp>
        <p:nvGrpSpPr>
          <p:cNvPr id="172" name="Group 171"/>
          <p:cNvGrpSpPr/>
          <p:nvPr/>
        </p:nvGrpSpPr>
        <p:grpSpPr>
          <a:xfrm>
            <a:off x="732272" y="4941090"/>
            <a:ext cx="858903" cy="893342"/>
            <a:chOff x="1339746" y="2747084"/>
            <a:chExt cx="926697" cy="963854"/>
          </a:xfrm>
        </p:grpSpPr>
        <p:sp>
          <p:nvSpPr>
            <p:cNvPr id="173" name="TextBox 172"/>
            <p:cNvSpPr txBox="1"/>
            <p:nvPr/>
          </p:nvSpPr>
          <p:spPr>
            <a:xfrm>
              <a:off x="1598299" y="2937702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1878044" y="2937702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sp>
          <p:nvSpPr>
            <p:cNvPr id="175" name="TextBox 174"/>
            <p:cNvSpPr txBox="1"/>
            <p:nvPr/>
          </p:nvSpPr>
          <p:spPr>
            <a:xfrm rot="16200000">
              <a:off x="1415918" y="3162358"/>
              <a:ext cx="3321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176" name="TextBox 175"/>
            <p:cNvSpPr txBox="1"/>
            <p:nvPr/>
          </p:nvSpPr>
          <p:spPr>
            <a:xfrm rot="16200000">
              <a:off x="1407103" y="3406959"/>
              <a:ext cx="3497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grpSp>
          <p:nvGrpSpPr>
            <p:cNvPr id="177" name="Group 176"/>
            <p:cNvGrpSpPr/>
            <p:nvPr/>
          </p:nvGrpSpPr>
          <p:grpSpPr>
            <a:xfrm>
              <a:off x="1517587" y="2999539"/>
              <a:ext cx="681721" cy="624704"/>
              <a:chOff x="1588939" y="3384606"/>
              <a:chExt cx="838200" cy="768096"/>
            </a:xfrm>
          </p:grpSpPr>
          <p:grpSp>
            <p:nvGrpSpPr>
              <p:cNvPr id="185" name="Group 184"/>
              <p:cNvGrpSpPr/>
              <p:nvPr/>
            </p:nvGrpSpPr>
            <p:grpSpPr>
              <a:xfrm>
                <a:off x="1588939" y="3513905"/>
                <a:ext cx="838200" cy="632967"/>
                <a:chOff x="838200" y="3505200"/>
                <a:chExt cx="1588770" cy="463062"/>
              </a:xfrm>
            </p:grpSpPr>
            <p:cxnSp>
              <p:nvCxnSpPr>
                <p:cNvPr id="192" name="Straight Connector 191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Straight Connector 192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Straight Connector 193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6" name="Group 185"/>
              <p:cNvGrpSpPr/>
              <p:nvPr/>
            </p:nvGrpSpPr>
            <p:grpSpPr>
              <a:xfrm rot="5400000">
                <a:off x="1699380" y="3425754"/>
                <a:ext cx="768096" cy="685800"/>
                <a:chOff x="838200" y="3505200"/>
                <a:chExt cx="1588770" cy="463062"/>
              </a:xfrm>
            </p:grpSpPr>
            <p:cxnSp>
              <p:nvCxnSpPr>
                <p:cNvPr id="189" name="Straight Connector 188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Straight Connector 189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Straight Connector 190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87" name="Straight Connector 186"/>
              <p:cNvCxnSpPr/>
              <p:nvPr/>
            </p:nvCxnSpPr>
            <p:spPr>
              <a:xfrm>
                <a:off x="1742040" y="3389245"/>
                <a:ext cx="6850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/>
              <p:cNvCxnSpPr/>
              <p:nvPr/>
            </p:nvCxnSpPr>
            <p:spPr>
              <a:xfrm>
                <a:off x="1588939" y="3513905"/>
                <a:ext cx="0" cy="6329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8" name="TextBox 177"/>
            <p:cNvSpPr txBox="1"/>
            <p:nvPr/>
          </p:nvSpPr>
          <p:spPr>
            <a:xfrm>
              <a:off x="1566520" y="2747084"/>
              <a:ext cx="699923" cy="3023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800" dirty="0" smtClean="0"/>
                <a:t>Clinical Diagnosis</a:t>
              </a:r>
              <a:endParaRPr lang="en-US" sz="800" dirty="0"/>
            </a:p>
          </p:txBody>
        </p:sp>
        <p:sp>
          <p:nvSpPr>
            <p:cNvPr id="179" name="TextBox 178"/>
            <p:cNvSpPr txBox="1"/>
            <p:nvPr/>
          </p:nvSpPr>
          <p:spPr>
            <a:xfrm rot="16200000">
              <a:off x="1137126" y="3292875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Test result</a:t>
              </a:r>
              <a:endParaRPr lang="en-US" sz="800" dirty="0"/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1636916" y="311218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27</a:t>
              </a:r>
              <a:endParaRPr lang="en-US" sz="900" dirty="0"/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665770" y="3372586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2</a:t>
              </a:r>
              <a:endParaRPr lang="en-US" sz="900" dirty="0"/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1944413" y="3112182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0</a:t>
              </a:r>
              <a:endParaRPr lang="en-US" sz="900" dirty="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909848" y="337258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30</a:t>
              </a:r>
              <a:endParaRPr lang="en-US" sz="900" dirty="0"/>
            </a:p>
          </p:txBody>
        </p:sp>
      </p:grpSp>
      <p:grpSp>
        <p:nvGrpSpPr>
          <p:cNvPr id="195" name="Group 194"/>
          <p:cNvGrpSpPr/>
          <p:nvPr/>
        </p:nvGrpSpPr>
        <p:grpSpPr>
          <a:xfrm>
            <a:off x="1873789" y="4941090"/>
            <a:ext cx="858903" cy="893341"/>
            <a:chOff x="4235346" y="2735249"/>
            <a:chExt cx="926697" cy="963853"/>
          </a:xfrm>
        </p:grpSpPr>
        <p:sp>
          <p:nvSpPr>
            <p:cNvPr id="196" name="TextBox 195"/>
            <p:cNvSpPr txBox="1"/>
            <p:nvPr/>
          </p:nvSpPr>
          <p:spPr>
            <a:xfrm>
              <a:off x="4497935" y="2925867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4773644" y="2925867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sp>
          <p:nvSpPr>
            <p:cNvPr id="198" name="TextBox 197"/>
            <p:cNvSpPr txBox="1"/>
            <p:nvPr/>
          </p:nvSpPr>
          <p:spPr>
            <a:xfrm rot="16200000">
              <a:off x="4311518" y="3141388"/>
              <a:ext cx="3321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199" name="TextBox 198"/>
            <p:cNvSpPr txBox="1"/>
            <p:nvPr/>
          </p:nvSpPr>
          <p:spPr>
            <a:xfrm rot="16200000">
              <a:off x="4302703" y="3395124"/>
              <a:ext cx="3497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grpSp>
          <p:nvGrpSpPr>
            <p:cNvPr id="200" name="Group 199"/>
            <p:cNvGrpSpPr/>
            <p:nvPr/>
          </p:nvGrpSpPr>
          <p:grpSpPr>
            <a:xfrm>
              <a:off x="4413187" y="2987704"/>
              <a:ext cx="681721" cy="624704"/>
              <a:chOff x="1588939" y="3384606"/>
              <a:chExt cx="838200" cy="768096"/>
            </a:xfrm>
          </p:grpSpPr>
          <p:grpSp>
            <p:nvGrpSpPr>
              <p:cNvPr id="208" name="Group 207"/>
              <p:cNvGrpSpPr/>
              <p:nvPr/>
            </p:nvGrpSpPr>
            <p:grpSpPr>
              <a:xfrm>
                <a:off x="1588939" y="3513905"/>
                <a:ext cx="838200" cy="632967"/>
                <a:chOff x="838200" y="3505200"/>
                <a:chExt cx="1588770" cy="463062"/>
              </a:xfrm>
            </p:grpSpPr>
            <p:cxnSp>
              <p:nvCxnSpPr>
                <p:cNvPr id="215" name="Straight Connector 214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Straight Connector 215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7" name="Straight Connector 216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9" name="Group 208"/>
              <p:cNvGrpSpPr/>
              <p:nvPr/>
            </p:nvGrpSpPr>
            <p:grpSpPr>
              <a:xfrm rot="5400000">
                <a:off x="1699380" y="3425754"/>
                <a:ext cx="768096" cy="685800"/>
                <a:chOff x="838200" y="3505200"/>
                <a:chExt cx="1588770" cy="463062"/>
              </a:xfrm>
            </p:grpSpPr>
            <p:cxnSp>
              <p:nvCxnSpPr>
                <p:cNvPr id="212" name="Straight Connector 211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3" name="Straight Connector 212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Straight Connector 213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10" name="Straight Connector 209"/>
              <p:cNvCxnSpPr/>
              <p:nvPr/>
            </p:nvCxnSpPr>
            <p:spPr>
              <a:xfrm>
                <a:off x="1742040" y="3389245"/>
                <a:ext cx="6850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>
                <a:off x="1588939" y="3513905"/>
                <a:ext cx="0" cy="6329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1" name="TextBox 200"/>
            <p:cNvSpPr txBox="1"/>
            <p:nvPr/>
          </p:nvSpPr>
          <p:spPr>
            <a:xfrm>
              <a:off x="4462120" y="2735249"/>
              <a:ext cx="699923" cy="3023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800" dirty="0" smtClean="0"/>
                <a:t>Clinical Diagnosis</a:t>
              </a:r>
              <a:endParaRPr lang="en-US" sz="800" dirty="0"/>
            </a:p>
          </p:txBody>
        </p:sp>
        <p:sp>
          <p:nvSpPr>
            <p:cNvPr id="202" name="TextBox 201"/>
            <p:cNvSpPr txBox="1"/>
            <p:nvPr/>
          </p:nvSpPr>
          <p:spPr>
            <a:xfrm rot="16200000">
              <a:off x="4032726" y="3281039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Test result</a:t>
              </a:r>
              <a:endParaRPr lang="en-US" sz="800" dirty="0"/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4532516" y="3100347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24</a:t>
              </a:r>
              <a:endParaRPr lang="en-US" sz="900" dirty="0"/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4561370" y="3360751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5</a:t>
              </a:r>
              <a:endParaRPr lang="en-US" sz="900" dirty="0"/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4840013" y="3100347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0</a:t>
              </a:r>
              <a:endParaRPr lang="en-US" sz="900" dirty="0"/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4805448" y="3360751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30</a:t>
              </a:r>
              <a:endParaRPr lang="en-US" sz="900" dirty="0"/>
            </a:p>
          </p:txBody>
        </p:sp>
      </p:grpSp>
      <p:grpSp>
        <p:nvGrpSpPr>
          <p:cNvPr id="218" name="Group 217"/>
          <p:cNvGrpSpPr/>
          <p:nvPr/>
        </p:nvGrpSpPr>
        <p:grpSpPr>
          <a:xfrm>
            <a:off x="732272" y="6127029"/>
            <a:ext cx="858903" cy="884875"/>
            <a:chOff x="3874947" y="2694147"/>
            <a:chExt cx="926697" cy="954719"/>
          </a:xfrm>
        </p:grpSpPr>
        <p:sp>
          <p:nvSpPr>
            <p:cNvPr id="219" name="TextBox 218"/>
            <p:cNvSpPr txBox="1"/>
            <p:nvPr/>
          </p:nvSpPr>
          <p:spPr>
            <a:xfrm>
              <a:off x="4137536" y="2884765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4413245" y="2884765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sp>
          <p:nvSpPr>
            <p:cNvPr id="221" name="TextBox 220"/>
            <p:cNvSpPr txBox="1"/>
            <p:nvPr/>
          </p:nvSpPr>
          <p:spPr>
            <a:xfrm rot="16200000">
              <a:off x="3951119" y="3109421"/>
              <a:ext cx="3321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222" name="TextBox 221"/>
            <p:cNvSpPr txBox="1"/>
            <p:nvPr/>
          </p:nvSpPr>
          <p:spPr>
            <a:xfrm rot="16200000">
              <a:off x="3942304" y="3354022"/>
              <a:ext cx="3497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grpSp>
          <p:nvGrpSpPr>
            <p:cNvPr id="223" name="Group 222"/>
            <p:cNvGrpSpPr/>
            <p:nvPr/>
          </p:nvGrpSpPr>
          <p:grpSpPr>
            <a:xfrm>
              <a:off x="4052788" y="2946602"/>
              <a:ext cx="681721" cy="624704"/>
              <a:chOff x="1588939" y="3384606"/>
              <a:chExt cx="838200" cy="768096"/>
            </a:xfrm>
          </p:grpSpPr>
          <p:grpSp>
            <p:nvGrpSpPr>
              <p:cNvPr id="231" name="Group 230"/>
              <p:cNvGrpSpPr/>
              <p:nvPr/>
            </p:nvGrpSpPr>
            <p:grpSpPr>
              <a:xfrm>
                <a:off x="1588939" y="3513905"/>
                <a:ext cx="838200" cy="632967"/>
                <a:chOff x="838200" y="3505200"/>
                <a:chExt cx="1588770" cy="463062"/>
              </a:xfrm>
            </p:grpSpPr>
            <p:cxnSp>
              <p:nvCxnSpPr>
                <p:cNvPr id="238" name="Straight Connector 237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9" name="Straight Connector 238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0" name="Straight Connector 239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2" name="Group 231"/>
              <p:cNvGrpSpPr/>
              <p:nvPr/>
            </p:nvGrpSpPr>
            <p:grpSpPr>
              <a:xfrm rot="5400000">
                <a:off x="1699380" y="3425754"/>
                <a:ext cx="768096" cy="685800"/>
                <a:chOff x="838200" y="3505200"/>
                <a:chExt cx="1588770" cy="463062"/>
              </a:xfrm>
            </p:grpSpPr>
            <p:cxnSp>
              <p:nvCxnSpPr>
                <p:cNvPr id="235" name="Straight Connector 234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6" name="Straight Connector 235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7" name="Straight Connector 236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33" name="Straight Connector 232"/>
              <p:cNvCxnSpPr/>
              <p:nvPr/>
            </p:nvCxnSpPr>
            <p:spPr>
              <a:xfrm>
                <a:off x="1742040" y="3389245"/>
                <a:ext cx="6850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/>
              <p:cNvCxnSpPr/>
              <p:nvPr/>
            </p:nvCxnSpPr>
            <p:spPr>
              <a:xfrm>
                <a:off x="1588939" y="3513905"/>
                <a:ext cx="0" cy="6329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4" name="TextBox 223"/>
            <p:cNvSpPr txBox="1"/>
            <p:nvPr/>
          </p:nvSpPr>
          <p:spPr>
            <a:xfrm>
              <a:off x="4101721" y="2694147"/>
              <a:ext cx="699923" cy="3023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800" dirty="0" smtClean="0"/>
                <a:t>Clinical Diagnosis</a:t>
              </a:r>
              <a:endParaRPr lang="en-US" sz="800" dirty="0"/>
            </a:p>
          </p:txBody>
        </p:sp>
        <p:sp>
          <p:nvSpPr>
            <p:cNvPr id="225" name="TextBox 224"/>
            <p:cNvSpPr txBox="1"/>
            <p:nvPr/>
          </p:nvSpPr>
          <p:spPr>
            <a:xfrm rot="16200000">
              <a:off x="3672327" y="3230803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Test result</a:t>
              </a:r>
              <a:endParaRPr lang="en-US" sz="800" dirty="0"/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4172117" y="3059245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20</a:t>
              </a:r>
              <a:endParaRPr lang="en-US" sz="900" dirty="0"/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4200971" y="3319649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/>
                <a:t>9</a:t>
              </a:r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4479614" y="3059245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0</a:t>
              </a:r>
              <a:endParaRPr lang="en-US" sz="900" dirty="0"/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4445049" y="3319649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10</a:t>
              </a:r>
              <a:endParaRPr lang="en-US" sz="900" dirty="0"/>
            </a:p>
          </p:txBody>
        </p:sp>
      </p:grpSp>
      <p:grpSp>
        <p:nvGrpSpPr>
          <p:cNvPr id="241" name="Group 240"/>
          <p:cNvGrpSpPr/>
          <p:nvPr/>
        </p:nvGrpSpPr>
        <p:grpSpPr>
          <a:xfrm>
            <a:off x="1873789" y="6127032"/>
            <a:ext cx="858903" cy="893342"/>
            <a:chOff x="4235346" y="6469049"/>
            <a:chExt cx="926697" cy="963854"/>
          </a:xfrm>
        </p:grpSpPr>
        <p:sp>
          <p:nvSpPr>
            <p:cNvPr id="242" name="TextBox 241"/>
            <p:cNvSpPr txBox="1"/>
            <p:nvPr/>
          </p:nvSpPr>
          <p:spPr>
            <a:xfrm>
              <a:off x="4497935" y="6659667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4773644" y="6659667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sp>
          <p:nvSpPr>
            <p:cNvPr id="244" name="TextBox 243"/>
            <p:cNvSpPr txBox="1"/>
            <p:nvPr/>
          </p:nvSpPr>
          <p:spPr>
            <a:xfrm rot="16200000">
              <a:off x="4311518" y="6884323"/>
              <a:ext cx="3321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Pos</a:t>
              </a:r>
              <a:endParaRPr lang="en-US" sz="800" dirty="0"/>
            </a:p>
          </p:txBody>
        </p:sp>
        <p:sp>
          <p:nvSpPr>
            <p:cNvPr id="245" name="TextBox 244"/>
            <p:cNvSpPr txBox="1"/>
            <p:nvPr/>
          </p:nvSpPr>
          <p:spPr>
            <a:xfrm rot="16200000">
              <a:off x="4302704" y="7128925"/>
              <a:ext cx="3497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Neg</a:t>
              </a:r>
              <a:endParaRPr lang="en-US" sz="800" dirty="0"/>
            </a:p>
          </p:txBody>
        </p:sp>
        <p:grpSp>
          <p:nvGrpSpPr>
            <p:cNvPr id="246" name="Group 245"/>
            <p:cNvGrpSpPr/>
            <p:nvPr/>
          </p:nvGrpSpPr>
          <p:grpSpPr>
            <a:xfrm>
              <a:off x="4413187" y="6721504"/>
              <a:ext cx="681721" cy="624704"/>
              <a:chOff x="1588939" y="3384606"/>
              <a:chExt cx="838200" cy="768096"/>
            </a:xfrm>
          </p:grpSpPr>
          <p:grpSp>
            <p:nvGrpSpPr>
              <p:cNvPr id="254" name="Group 253"/>
              <p:cNvGrpSpPr/>
              <p:nvPr/>
            </p:nvGrpSpPr>
            <p:grpSpPr>
              <a:xfrm>
                <a:off x="1588939" y="3513905"/>
                <a:ext cx="838200" cy="632967"/>
                <a:chOff x="838200" y="3505200"/>
                <a:chExt cx="1588770" cy="463062"/>
              </a:xfrm>
            </p:grpSpPr>
            <p:cxnSp>
              <p:nvCxnSpPr>
                <p:cNvPr id="261" name="Straight Connector 260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Straight Connector 261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Straight Connector 262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5" name="Group 254"/>
              <p:cNvGrpSpPr/>
              <p:nvPr/>
            </p:nvGrpSpPr>
            <p:grpSpPr>
              <a:xfrm rot="5400000">
                <a:off x="1699380" y="3425754"/>
                <a:ext cx="768096" cy="685800"/>
                <a:chOff x="838200" y="3505200"/>
                <a:chExt cx="1588770" cy="463062"/>
              </a:xfrm>
            </p:grpSpPr>
            <p:cxnSp>
              <p:nvCxnSpPr>
                <p:cNvPr id="258" name="Straight Connector 257"/>
                <p:cNvCxnSpPr/>
                <p:nvPr/>
              </p:nvCxnSpPr>
              <p:spPr>
                <a:xfrm>
                  <a:off x="838200" y="35052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9" name="Straight Connector 258"/>
                <p:cNvCxnSpPr/>
                <p:nvPr/>
              </p:nvCxnSpPr>
              <p:spPr>
                <a:xfrm>
                  <a:off x="838200" y="3733800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0" name="Straight Connector 259"/>
                <p:cNvCxnSpPr/>
                <p:nvPr/>
              </p:nvCxnSpPr>
              <p:spPr>
                <a:xfrm>
                  <a:off x="838200" y="3968262"/>
                  <a:ext cx="158877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56" name="Straight Connector 255"/>
              <p:cNvCxnSpPr/>
              <p:nvPr/>
            </p:nvCxnSpPr>
            <p:spPr>
              <a:xfrm>
                <a:off x="1742040" y="3389245"/>
                <a:ext cx="6850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Straight Connector 256"/>
              <p:cNvCxnSpPr/>
              <p:nvPr/>
            </p:nvCxnSpPr>
            <p:spPr>
              <a:xfrm>
                <a:off x="1588939" y="3513905"/>
                <a:ext cx="0" cy="6329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7" name="TextBox 246"/>
            <p:cNvSpPr txBox="1"/>
            <p:nvPr/>
          </p:nvSpPr>
          <p:spPr>
            <a:xfrm>
              <a:off x="4462120" y="6469049"/>
              <a:ext cx="699923" cy="3023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800" dirty="0" smtClean="0"/>
                <a:t>Clinical Diagnosis</a:t>
              </a:r>
              <a:endParaRPr lang="en-US" sz="800" dirty="0"/>
            </a:p>
          </p:txBody>
        </p:sp>
        <p:sp>
          <p:nvSpPr>
            <p:cNvPr id="248" name="TextBox 247"/>
            <p:cNvSpPr txBox="1"/>
            <p:nvPr/>
          </p:nvSpPr>
          <p:spPr>
            <a:xfrm rot="16200000">
              <a:off x="4032726" y="7014840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Test result</a:t>
              </a:r>
              <a:endParaRPr lang="en-US" sz="800" dirty="0"/>
            </a:p>
          </p:txBody>
        </p:sp>
        <p:sp>
          <p:nvSpPr>
            <p:cNvPr id="249" name="TextBox 248"/>
            <p:cNvSpPr txBox="1"/>
            <p:nvPr/>
          </p:nvSpPr>
          <p:spPr>
            <a:xfrm>
              <a:off x="4532516" y="6834147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22</a:t>
              </a:r>
              <a:endParaRPr lang="en-US" sz="900" dirty="0"/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4561370" y="7094551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7</a:t>
              </a:r>
              <a:endParaRPr lang="en-US" sz="900" dirty="0"/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4840013" y="6834147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/>
                <a:t>0</a:t>
              </a:r>
              <a:endParaRPr lang="en-US" sz="900" dirty="0"/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4805448" y="7094551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10</a:t>
              </a:r>
              <a:endParaRPr lang="en-US" sz="900" dirty="0"/>
            </a:p>
          </p:txBody>
        </p:sp>
      </p:grpSp>
      <p:sp>
        <p:nvSpPr>
          <p:cNvPr id="264" name="TextBox 263"/>
          <p:cNvSpPr txBox="1"/>
          <p:nvPr/>
        </p:nvSpPr>
        <p:spPr>
          <a:xfrm>
            <a:off x="735675" y="4700940"/>
            <a:ext cx="94128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 smtClean="0"/>
              <a:t>BGI RT-qPCR</a:t>
            </a:r>
          </a:p>
          <a:p>
            <a:pPr algn="ctr">
              <a:lnSpc>
                <a:spcPts val="900"/>
              </a:lnSpc>
            </a:pPr>
            <a:r>
              <a:rPr lang="en-US" sz="900" b="1" dirty="0" smtClean="0"/>
              <a:t>(BGI extraction)</a:t>
            </a:r>
            <a:endParaRPr lang="en-US" sz="900" b="1" dirty="0"/>
          </a:p>
        </p:txBody>
      </p:sp>
      <p:sp>
        <p:nvSpPr>
          <p:cNvPr id="265" name="TextBox 264"/>
          <p:cNvSpPr txBox="1"/>
          <p:nvPr/>
        </p:nvSpPr>
        <p:spPr>
          <a:xfrm>
            <a:off x="1765530" y="4700940"/>
            <a:ext cx="111280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 smtClean="0"/>
              <a:t>BGI RT-qPCR</a:t>
            </a:r>
          </a:p>
          <a:p>
            <a:pPr algn="ctr">
              <a:lnSpc>
                <a:spcPts val="900"/>
              </a:lnSpc>
            </a:pPr>
            <a:r>
              <a:rPr lang="en-US" sz="900" b="1" dirty="0" smtClean="0"/>
              <a:t>(</a:t>
            </a:r>
            <a:r>
              <a:rPr lang="en-US" sz="900" b="1" dirty="0" err="1" smtClean="0"/>
              <a:t>Qiagen</a:t>
            </a:r>
            <a:r>
              <a:rPr lang="en-US" sz="900" b="1" dirty="0" smtClean="0"/>
              <a:t> extraction)</a:t>
            </a:r>
            <a:endParaRPr lang="en-US" sz="900" b="1" dirty="0"/>
          </a:p>
        </p:txBody>
      </p:sp>
      <p:sp>
        <p:nvSpPr>
          <p:cNvPr id="266" name="TextBox 265"/>
          <p:cNvSpPr txBox="1"/>
          <p:nvPr/>
        </p:nvSpPr>
        <p:spPr>
          <a:xfrm>
            <a:off x="640652" y="5889171"/>
            <a:ext cx="113204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 err="1" smtClean="0"/>
              <a:t>Norgen</a:t>
            </a:r>
            <a:r>
              <a:rPr lang="en-US" sz="900" b="1" dirty="0" smtClean="0"/>
              <a:t> N1 RT-qPCR</a:t>
            </a:r>
          </a:p>
          <a:p>
            <a:pPr algn="ctr">
              <a:lnSpc>
                <a:spcPts val="900"/>
              </a:lnSpc>
            </a:pPr>
            <a:r>
              <a:rPr lang="en-US" sz="900" b="1" dirty="0" smtClean="0"/>
              <a:t>(BGI extraction)</a:t>
            </a:r>
            <a:endParaRPr lang="en-US" sz="900" b="1" dirty="0"/>
          </a:p>
        </p:txBody>
      </p:sp>
      <p:sp>
        <p:nvSpPr>
          <p:cNvPr id="267" name="TextBox 266"/>
          <p:cNvSpPr txBox="1"/>
          <p:nvPr/>
        </p:nvSpPr>
        <p:spPr>
          <a:xfrm>
            <a:off x="1776055" y="5889171"/>
            <a:ext cx="113204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sz="900" b="1" dirty="0" err="1" smtClean="0"/>
              <a:t>Norgen</a:t>
            </a:r>
            <a:r>
              <a:rPr lang="en-US" sz="900" b="1" dirty="0" smtClean="0"/>
              <a:t> N2 RT-qPCR</a:t>
            </a:r>
          </a:p>
          <a:p>
            <a:pPr algn="ctr">
              <a:lnSpc>
                <a:spcPts val="900"/>
              </a:lnSpc>
            </a:pPr>
            <a:r>
              <a:rPr lang="en-US" sz="900" b="1" dirty="0" smtClean="0"/>
              <a:t>(BGI extraction)</a:t>
            </a:r>
            <a:endParaRPr lang="en-US" sz="900" b="1" dirty="0"/>
          </a:p>
        </p:txBody>
      </p:sp>
      <p:grpSp>
        <p:nvGrpSpPr>
          <p:cNvPr id="268" name="Group 267"/>
          <p:cNvGrpSpPr/>
          <p:nvPr/>
        </p:nvGrpSpPr>
        <p:grpSpPr>
          <a:xfrm>
            <a:off x="3662134" y="682448"/>
            <a:ext cx="1696331" cy="1919519"/>
            <a:chOff x="3228382" y="850777"/>
            <a:chExt cx="1696331" cy="1919519"/>
          </a:xfrm>
        </p:grpSpPr>
        <p:grpSp>
          <p:nvGrpSpPr>
            <p:cNvPr id="269" name="Group 268"/>
            <p:cNvGrpSpPr/>
            <p:nvPr/>
          </p:nvGrpSpPr>
          <p:grpSpPr>
            <a:xfrm>
              <a:off x="3232308" y="850777"/>
              <a:ext cx="1692405" cy="1919519"/>
              <a:chOff x="3786095" y="5638800"/>
              <a:chExt cx="1692405" cy="1919519"/>
            </a:xfrm>
          </p:grpSpPr>
          <p:graphicFrame>
            <p:nvGraphicFramePr>
              <p:cNvPr id="271" name="Chart 27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24066720"/>
                  </p:ext>
                </p:extLst>
              </p:nvPr>
            </p:nvGraphicFramePr>
            <p:xfrm>
              <a:off x="3913340" y="5638800"/>
              <a:ext cx="1565160" cy="1752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cxnSp>
            <p:nvCxnSpPr>
              <p:cNvPr id="272" name="Straight Connector 271"/>
              <p:cNvCxnSpPr/>
              <p:nvPr/>
            </p:nvCxnSpPr>
            <p:spPr>
              <a:xfrm>
                <a:off x="4327846" y="7349251"/>
                <a:ext cx="4745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TextBox 272"/>
              <p:cNvSpPr txBox="1"/>
              <p:nvPr/>
            </p:nvSpPr>
            <p:spPr>
              <a:xfrm>
                <a:off x="4227240" y="7327487"/>
                <a:ext cx="63831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CoV2-neg</a:t>
                </a:r>
                <a:endParaRPr lang="en-US" sz="900" dirty="0"/>
              </a:p>
            </p:txBody>
          </p:sp>
          <p:cxnSp>
            <p:nvCxnSpPr>
              <p:cNvPr id="274" name="Straight Connector 273"/>
              <p:cNvCxnSpPr/>
              <p:nvPr/>
            </p:nvCxnSpPr>
            <p:spPr>
              <a:xfrm>
                <a:off x="4904358" y="7349251"/>
                <a:ext cx="4745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5" name="TextBox 274"/>
              <p:cNvSpPr txBox="1"/>
              <p:nvPr/>
            </p:nvSpPr>
            <p:spPr>
              <a:xfrm>
                <a:off x="4818052" y="7327487"/>
                <a:ext cx="6319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CoV2-pos</a:t>
                </a:r>
                <a:endParaRPr lang="en-US" sz="900" dirty="0"/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3786095" y="7105791"/>
                <a:ext cx="499392" cy="1997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800"/>
                  </a:lnSpc>
                </a:pPr>
                <a:r>
                  <a:rPr lang="en-US" sz="900" dirty="0" smtClean="0"/>
                  <a:t>Sample:</a:t>
                </a:r>
                <a:endParaRPr lang="en-US" sz="900" dirty="0"/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 rot="16200000">
                <a:off x="4162874" y="6811165"/>
                <a:ext cx="349776" cy="191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Neg</a:t>
                </a:r>
                <a:endParaRPr lang="en-US" sz="800" dirty="0"/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 rot="16200000">
                <a:off x="4295754" y="6811165"/>
                <a:ext cx="349776" cy="191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Neg</a:t>
                </a:r>
                <a:endParaRPr lang="en-US" sz="800" dirty="0"/>
              </a:p>
            </p:txBody>
          </p:sp>
          <p:sp>
            <p:nvSpPr>
              <p:cNvPr id="279" name="TextBox 278"/>
              <p:cNvSpPr txBox="1"/>
              <p:nvPr/>
            </p:nvSpPr>
            <p:spPr>
              <a:xfrm rot="16200000">
                <a:off x="4437624" y="6811165"/>
                <a:ext cx="349776" cy="191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Neg</a:t>
                </a:r>
                <a:endParaRPr lang="en-US" sz="800" dirty="0"/>
              </a:p>
            </p:txBody>
          </p:sp>
          <p:sp>
            <p:nvSpPr>
              <p:cNvPr id="280" name="TextBox 279"/>
              <p:cNvSpPr txBox="1"/>
              <p:nvPr/>
            </p:nvSpPr>
            <p:spPr>
              <a:xfrm rot="16200000">
                <a:off x="4580442" y="6811165"/>
                <a:ext cx="349776" cy="1916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Neg</a:t>
                </a:r>
                <a:endParaRPr lang="en-US" sz="800" dirty="0"/>
              </a:p>
            </p:txBody>
          </p:sp>
        </p:grpSp>
        <p:sp>
          <p:nvSpPr>
            <p:cNvPr id="270" name="TextBox 269"/>
            <p:cNvSpPr txBox="1"/>
            <p:nvPr/>
          </p:nvSpPr>
          <p:spPr>
            <a:xfrm>
              <a:off x="3228382" y="2569343"/>
              <a:ext cx="548548" cy="199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dirty="0" smtClean="0"/>
                <a:t>Clinical:</a:t>
              </a:r>
              <a:endParaRPr lang="en-US" sz="900" dirty="0"/>
            </a:p>
          </p:txBody>
        </p:sp>
      </p:grpSp>
      <p:grpSp>
        <p:nvGrpSpPr>
          <p:cNvPr id="281" name="Group 280"/>
          <p:cNvGrpSpPr/>
          <p:nvPr/>
        </p:nvGrpSpPr>
        <p:grpSpPr>
          <a:xfrm>
            <a:off x="5285676" y="898471"/>
            <a:ext cx="1038924" cy="1452604"/>
            <a:chOff x="4842018" y="1066800"/>
            <a:chExt cx="1038924" cy="1452604"/>
          </a:xfrm>
        </p:grpSpPr>
        <p:pic>
          <p:nvPicPr>
            <p:cNvPr id="282" name="Picture 3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30" r="16337" b="20980"/>
            <a:stretch/>
          </p:blipFill>
          <p:spPr bwMode="auto">
            <a:xfrm>
              <a:off x="5135995" y="1066800"/>
              <a:ext cx="744947" cy="11781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3" name="TextBox 282"/>
            <p:cNvSpPr txBox="1"/>
            <p:nvPr/>
          </p:nvSpPr>
          <p:spPr>
            <a:xfrm>
              <a:off x="5235463" y="1073150"/>
              <a:ext cx="5148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 = 0.19</a:t>
              </a:r>
              <a:endParaRPr lang="en-US" sz="800" dirty="0"/>
            </a:p>
          </p:txBody>
        </p:sp>
        <p:sp>
          <p:nvSpPr>
            <p:cNvPr id="284" name="TextBox 283"/>
            <p:cNvSpPr txBox="1"/>
            <p:nvPr/>
          </p:nvSpPr>
          <p:spPr>
            <a:xfrm rot="16200000">
              <a:off x="4500417" y="1564890"/>
              <a:ext cx="9140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N2 primers (Ct)</a:t>
              </a:r>
              <a:endParaRPr lang="en-US" sz="900" b="1" dirty="0"/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4949963" y="10995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5</a:t>
              </a:r>
              <a:endParaRPr lang="en-US" sz="800" dirty="0"/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4949963" y="129635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0</a:t>
              </a:r>
              <a:endParaRPr lang="en-US" sz="800" dirty="0"/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4949963" y="14932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5</a:t>
              </a:r>
              <a:endParaRPr lang="en-US" sz="800" dirty="0"/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4949963" y="16837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0</a:t>
              </a:r>
              <a:endParaRPr lang="en-US" sz="800" dirty="0"/>
            </a:p>
          </p:txBody>
        </p:sp>
        <p:sp>
          <p:nvSpPr>
            <p:cNvPr id="289" name="TextBox 288"/>
            <p:cNvSpPr txBox="1"/>
            <p:nvPr/>
          </p:nvSpPr>
          <p:spPr>
            <a:xfrm>
              <a:off x="4949963" y="18869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</a:t>
              </a:r>
              <a:r>
                <a:rPr lang="en-US" sz="800" dirty="0" smtClean="0"/>
                <a:t>5</a:t>
              </a:r>
              <a:endParaRPr lang="en-US" sz="800" dirty="0"/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4949963" y="20774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10</a:t>
              </a:r>
              <a:endParaRPr lang="en-US" sz="800" dirty="0"/>
            </a:p>
          </p:txBody>
        </p:sp>
        <p:sp>
          <p:nvSpPr>
            <p:cNvPr id="291" name="TextBox 290"/>
            <p:cNvSpPr txBox="1"/>
            <p:nvPr/>
          </p:nvSpPr>
          <p:spPr>
            <a:xfrm rot="18900000">
              <a:off x="5010739" y="2288572"/>
              <a:ext cx="5325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/>
                <a:t>Norgen</a:t>
              </a:r>
              <a:endParaRPr lang="en-US" sz="900" dirty="0"/>
            </a:p>
          </p:txBody>
        </p:sp>
        <p:sp>
          <p:nvSpPr>
            <p:cNvPr id="292" name="TextBox 291"/>
            <p:cNvSpPr txBox="1"/>
            <p:nvPr/>
          </p:nvSpPr>
          <p:spPr>
            <a:xfrm rot="18900000">
              <a:off x="5285454" y="2275872"/>
              <a:ext cx="5164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/>
                <a:t>Qiagen</a:t>
              </a:r>
              <a:endParaRPr lang="en-US" sz="900" dirty="0"/>
            </a:p>
          </p:txBody>
        </p:sp>
      </p:grpSp>
      <p:sp>
        <p:nvSpPr>
          <p:cNvPr id="298" name="TextBox 297"/>
          <p:cNvSpPr txBox="1"/>
          <p:nvPr/>
        </p:nvSpPr>
        <p:spPr>
          <a:xfrm>
            <a:off x="3511164" y="61537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B</a:t>
            </a:r>
          </a:p>
        </p:txBody>
      </p:sp>
      <p:sp>
        <p:nvSpPr>
          <p:cNvPr id="299" name="TextBox 298"/>
          <p:cNvSpPr txBox="1"/>
          <p:nvPr/>
        </p:nvSpPr>
        <p:spPr>
          <a:xfrm>
            <a:off x="2856642" y="2819720"/>
            <a:ext cx="272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</a:t>
            </a:r>
            <a:endParaRPr lang="en-US" sz="1100" b="1" dirty="0"/>
          </a:p>
        </p:txBody>
      </p:sp>
      <p:sp>
        <p:nvSpPr>
          <p:cNvPr id="300" name="TextBox 299"/>
          <p:cNvSpPr txBox="1"/>
          <p:nvPr/>
        </p:nvSpPr>
        <p:spPr>
          <a:xfrm>
            <a:off x="406898" y="4648200"/>
            <a:ext cx="2535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E</a:t>
            </a:r>
            <a:endParaRPr lang="en-US" sz="1100" b="1" dirty="0"/>
          </a:p>
        </p:txBody>
      </p:sp>
      <p:grpSp>
        <p:nvGrpSpPr>
          <p:cNvPr id="10" name="Group 9"/>
          <p:cNvGrpSpPr/>
          <p:nvPr/>
        </p:nvGrpSpPr>
        <p:grpSpPr>
          <a:xfrm>
            <a:off x="587811" y="721960"/>
            <a:ext cx="3474079" cy="1983324"/>
            <a:chOff x="596128" y="1144486"/>
            <a:chExt cx="3474079" cy="1983324"/>
          </a:xfrm>
        </p:grpSpPr>
        <p:grpSp>
          <p:nvGrpSpPr>
            <p:cNvPr id="294" name="Group 293"/>
            <p:cNvGrpSpPr/>
            <p:nvPr/>
          </p:nvGrpSpPr>
          <p:grpSpPr>
            <a:xfrm>
              <a:off x="596128" y="1144486"/>
              <a:ext cx="2072681" cy="1797778"/>
              <a:chOff x="685800" y="681566"/>
              <a:chExt cx="2110887" cy="1830917"/>
            </a:xfrm>
          </p:grpSpPr>
          <p:graphicFrame>
            <p:nvGraphicFramePr>
              <p:cNvPr id="295" name="Chart 29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92469853"/>
                  </p:ext>
                </p:extLst>
              </p:nvPr>
            </p:nvGraphicFramePr>
            <p:xfrm>
              <a:off x="685800" y="681566"/>
              <a:ext cx="2110887" cy="183091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296" name="TextBox 295"/>
              <p:cNvSpPr txBox="1"/>
              <p:nvPr/>
            </p:nvSpPr>
            <p:spPr>
              <a:xfrm>
                <a:off x="1849565" y="1826683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Neg</a:t>
                </a:r>
                <a:endParaRPr lang="en-US" sz="800" dirty="0"/>
              </a:p>
            </p:txBody>
          </p:sp>
        </p:grpSp>
        <p:grpSp>
          <p:nvGrpSpPr>
            <p:cNvPr id="297" name="Group 296"/>
            <p:cNvGrpSpPr/>
            <p:nvPr/>
          </p:nvGrpSpPr>
          <p:grpSpPr>
            <a:xfrm>
              <a:off x="1997526" y="1153897"/>
              <a:ext cx="2072681" cy="1797778"/>
              <a:chOff x="4201543" y="830130"/>
              <a:chExt cx="2110887" cy="1830917"/>
            </a:xfrm>
          </p:grpSpPr>
          <p:sp>
            <p:nvSpPr>
              <p:cNvPr id="301" name="TextBox 300"/>
              <p:cNvSpPr txBox="1"/>
              <p:nvPr/>
            </p:nvSpPr>
            <p:spPr>
              <a:xfrm>
                <a:off x="5365224" y="1994912"/>
                <a:ext cx="3497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Neg</a:t>
                </a:r>
                <a:endParaRPr lang="en-US" sz="800" dirty="0"/>
              </a:p>
            </p:txBody>
          </p:sp>
          <p:graphicFrame>
            <p:nvGraphicFramePr>
              <p:cNvPr id="302" name="Chart 30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7418415"/>
                  </p:ext>
                </p:extLst>
              </p:nvPr>
            </p:nvGraphicFramePr>
            <p:xfrm>
              <a:off x="4201543" y="830130"/>
              <a:ext cx="2110887" cy="183091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</p:grpSp>
        <p:grpSp>
          <p:nvGrpSpPr>
            <p:cNvPr id="303" name="Group 302"/>
            <p:cNvGrpSpPr/>
            <p:nvPr/>
          </p:nvGrpSpPr>
          <p:grpSpPr>
            <a:xfrm>
              <a:off x="1828800" y="2911366"/>
              <a:ext cx="1600200" cy="216444"/>
              <a:chOff x="1219200" y="4387578"/>
              <a:chExt cx="1600200" cy="216444"/>
            </a:xfrm>
          </p:grpSpPr>
          <p:sp>
            <p:nvSpPr>
              <p:cNvPr id="304" name="TextBox 303"/>
              <p:cNvSpPr txBox="1"/>
              <p:nvPr/>
            </p:nvSpPr>
            <p:spPr>
              <a:xfrm>
                <a:off x="1987121" y="4387578"/>
                <a:ext cx="8322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384-well (10 µl)</a:t>
                </a:r>
                <a:endParaRPr lang="en-US" sz="800" dirty="0"/>
              </a:p>
            </p:txBody>
          </p:sp>
          <p:sp>
            <p:nvSpPr>
              <p:cNvPr id="305" name="TextBox 304"/>
              <p:cNvSpPr txBox="1"/>
              <p:nvPr/>
            </p:nvSpPr>
            <p:spPr>
              <a:xfrm>
                <a:off x="1219200" y="4388578"/>
                <a:ext cx="7809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96-well (20 µl)</a:t>
                </a:r>
                <a:endParaRPr lang="en-US" sz="800" dirty="0"/>
              </a:p>
            </p:txBody>
          </p:sp>
          <p:sp>
            <p:nvSpPr>
              <p:cNvPr id="306" name="Rectangle 305"/>
              <p:cNvSpPr/>
              <p:nvPr/>
            </p:nvSpPr>
            <p:spPr>
              <a:xfrm>
                <a:off x="1997795" y="4472376"/>
                <a:ext cx="52753" cy="5275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7" name="Rectangle 306"/>
              <p:cNvSpPr/>
              <p:nvPr/>
            </p:nvSpPr>
            <p:spPr>
              <a:xfrm>
                <a:off x="1229874" y="4472993"/>
                <a:ext cx="52753" cy="52753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08" name="TextBox 307"/>
          <p:cNvSpPr txBox="1"/>
          <p:nvPr/>
        </p:nvSpPr>
        <p:spPr>
          <a:xfrm>
            <a:off x="406898" y="615372"/>
            <a:ext cx="269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A</a:t>
            </a:r>
            <a:endParaRPr lang="en-US" sz="1100" b="1" dirty="0"/>
          </a:p>
        </p:txBody>
      </p:sp>
      <p:grpSp>
        <p:nvGrpSpPr>
          <p:cNvPr id="9" name="Group 8"/>
          <p:cNvGrpSpPr/>
          <p:nvPr/>
        </p:nvGrpSpPr>
        <p:grpSpPr>
          <a:xfrm>
            <a:off x="1683029" y="2884247"/>
            <a:ext cx="850369" cy="1477854"/>
            <a:chOff x="777241" y="4914103"/>
            <a:chExt cx="850369" cy="1477854"/>
          </a:xfrm>
        </p:grpSpPr>
        <p:pic>
          <p:nvPicPr>
            <p:cNvPr id="1027" name="Picture 3"/>
            <p:cNvPicPr>
              <a:picLocks noChangeArrowheads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52" r="12413" b="12922"/>
            <a:stretch/>
          </p:blipFill>
          <p:spPr bwMode="auto">
            <a:xfrm>
              <a:off x="1098494" y="4914103"/>
              <a:ext cx="529116" cy="11818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4" name="TextBox 103"/>
            <p:cNvSpPr txBox="1"/>
            <p:nvPr/>
          </p:nvSpPr>
          <p:spPr>
            <a:xfrm>
              <a:off x="1039139" y="5018027"/>
              <a:ext cx="5661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p</a:t>
              </a:r>
              <a:r>
                <a:rPr lang="en-US" sz="800" dirty="0" smtClean="0"/>
                <a:t> </a:t>
              </a:r>
              <a:r>
                <a:rPr lang="en-US" sz="800" dirty="0"/>
                <a:t>=</a:t>
              </a:r>
              <a:r>
                <a:rPr lang="en-US" sz="800" dirty="0" smtClean="0"/>
                <a:t> 0.004</a:t>
              </a:r>
              <a:endParaRPr lang="en-US" sz="800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887614" y="494623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5</a:t>
              </a:r>
              <a:endParaRPr lang="en-US" sz="800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887614" y="518957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30</a:t>
              </a:r>
              <a:endParaRPr lang="en-US" sz="800" dirty="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887614" y="544705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5</a:t>
              </a:r>
              <a:endParaRPr lang="en-US" sz="800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887614" y="568598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20</a:t>
              </a:r>
              <a:endParaRPr lang="en-US" sz="800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887614" y="592879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</a:t>
              </a:r>
              <a:r>
                <a:rPr lang="en-US" sz="800" dirty="0" smtClean="0"/>
                <a:t>5</a:t>
              </a:r>
              <a:endParaRPr lang="en-US" sz="800" dirty="0"/>
            </a:p>
          </p:txBody>
        </p:sp>
        <p:sp>
          <p:nvSpPr>
            <p:cNvPr id="111" name="TextBox 110"/>
            <p:cNvSpPr txBox="1"/>
            <p:nvPr/>
          </p:nvSpPr>
          <p:spPr>
            <a:xfrm rot="18900000">
              <a:off x="789995" y="6161125"/>
              <a:ext cx="6896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 smtClean="0"/>
                <a:t>Norgen</a:t>
              </a:r>
              <a:r>
                <a:rPr lang="en-US" sz="900" dirty="0" smtClean="0"/>
                <a:t> N2</a:t>
              </a:r>
              <a:endParaRPr lang="en-US" sz="900" dirty="0"/>
            </a:p>
          </p:txBody>
        </p:sp>
        <p:sp>
          <p:nvSpPr>
            <p:cNvPr id="112" name="TextBox 111"/>
            <p:cNvSpPr txBox="1"/>
            <p:nvPr/>
          </p:nvSpPr>
          <p:spPr>
            <a:xfrm rot="18900000">
              <a:off x="1241661" y="6053015"/>
              <a:ext cx="34817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BGI</a:t>
              </a:r>
              <a:endParaRPr lang="en-US" sz="900" dirty="0"/>
            </a:p>
          </p:txBody>
        </p:sp>
        <p:sp>
          <p:nvSpPr>
            <p:cNvPr id="309" name="TextBox 308"/>
            <p:cNvSpPr txBox="1"/>
            <p:nvPr/>
          </p:nvSpPr>
          <p:spPr>
            <a:xfrm rot="16200000">
              <a:off x="442854" y="5420419"/>
              <a:ext cx="8996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Expression (Ct)</a:t>
              </a:r>
              <a:endParaRPr lang="en-US" sz="900" b="1" dirty="0"/>
            </a:p>
          </p:txBody>
        </p:sp>
      </p:grp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479136"/>
              </p:ext>
            </p:extLst>
          </p:nvPr>
        </p:nvGraphicFramePr>
        <p:xfrm>
          <a:off x="3147349" y="4741653"/>
          <a:ext cx="3024851" cy="1391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3351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0073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46891">
                <a:tc>
                  <a:txBody>
                    <a:bodyPr/>
                    <a:lstStyle/>
                    <a:p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pecificity (95% CI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Sensitivity (95% CI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2849">
                <a:tc>
                  <a:txBody>
                    <a:bodyPr/>
                    <a:lstStyle/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BGI RT-qPCR</a:t>
                      </a:r>
                    </a:p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(BGI extraction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100% (88.6,</a:t>
                      </a:r>
                      <a:r>
                        <a:rPr lang="en-US" sz="800" baseline="0" dirty="0" smtClean="0"/>
                        <a:t> 100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93.1% (78.0, 98.1)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2849">
                <a:tc>
                  <a:txBody>
                    <a:bodyPr/>
                    <a:lstStyle/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BGI RT-qPCR</a:t>
                      </a:r>
                    </a:p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(</a:t>
                      </a:r>
                      <a:r>
                        <a:rPr lang="en-US" sz="800" dirty="0" err="1" smtClean="0"/>
                        <a:t>Qiagen</a:t>
                      </a:r>
                      <a:r>
                        <a:rPr lang="en-US" sz="800" dirty="0" smtClean="0"/>
                        <a:t> extraction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100% (88.6,</a:t>
                      </a:r>
                      <a:r>
                        <a:rPr lang="en-US" sz="800" baseline="0" dirty="0" smtClean="0"/>
                        <a:t> 100)</a:t>
                      </a:r>
                      <a:endParaRPr lang="en-US" sz="800" dirty="0" smtClean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82.7% (65.5, 92.4)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72797">
                <a:tc>
                  <a:txBody>
                    <a:bodyPr/>
                    <a:lstStyle/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err="1" smtClean="0"/>
                        <a:t>Norgen</a:t>
                      </a:r>
                      <a:r>
                        <a:rPr lang="en-US" sz="800" dirty="0" smtClean="0"/>
                        <a:t> N1 RT-qPCR</a:t>
                      </a:r>
                    </a:p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(BGI extraction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100% (72.2,</a:t>
                      </a:r>
                      <a:r>
                        <a:rPr lang="en-US" sz="800" baseline="0" dirty="0" smtClean="0"/>
                        <a:t> 100)</a:t>
                      </a:r>
                      <a:endParaRPr lang="en-US" sz="800" dirty="0" smtClean="0"/>
                    </a:p>
                    <a:p>
                      <a:pPr algn="ctr">
                        <a:lnSpc>
                          <a:spcPts val="800"/>
                        </a:lnSpc>
                      </a:pP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69.0% (50.8, 82.7)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72797">
                <a:tc>
                  <a:txBody>
                    <a:bodyPr/>
                    <a:lstStyle/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err="1" smtClean="0"/>
                        <a:t>Norgen</a:t>
                      </a:r>
                      <a:r>
                        <a:rPr lang="en-US" sz="800" dirty="0" smtClean="0"/>
                        <a:t> N2 RT-qPCR</a:t>
                      </a:r>
                    </a:p>
                    <a:p>
                      <a:pPr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(BGI</a:t>
                      </a:r>
                      <a:r>
                        <a:rPr lang="en-US" sz="800" baseline="0" dirty="0" smtClean="0"/>
                        <a:t> extraction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100% (72.2,</a:t>
                      </a:r>
                      <a:r>
                        <a:rPr lang="en-US" sz="800" baseline="0" dirty="0" smtClean="0"/>
                        <a:t> 100)</a:t>
                      </a:r>
                      <a:endParaRPr lang="en-US" sz="800" dirty="0" smtClean="0"/>
                    </a:p>
                    <a:p>
                      <a:pPr algn="ctr">
                        <a:lnSpc>
                          <a:spcPts val="800"/>
                        </a:lnSpc>
                      </a:pP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</a:pPr>
                      <a:r>
                        <a:rPr lang="en-US" sz="800" dirty="0" smtClean="0"/>
                        <a:t>75.8% (57.9, 87.8)</a:t>
                      </a:r>
                      <a:endParaRPr lang="en-US" sz="8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124200" y="6267137"/>
            <a:ext cx="2470548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u="sng" dirty="0" smtClean="0"/>
              <a:t>p-values (Liddell’s test)</a:t>
            </a:r>
          </a:p>
          <a:p>
            <a:r>
              <a:rPr lang="en-US" sz="800" dirty="0" smtClean="0"/>
              <a:t>BGI vs </a:t>
            </a:r>
            <a:r>
              <a:rPr lang="en-US" sz="800" dirty="0" err="1" smtClean="0"/>
              <a:t>Qiagen</a:t>
            </a:r>
            <a:r>
              <a:rPr lang="en-US" sz="800" dirty="0" smtClean="0"/>
              <a:t> extractions (BGI RT-qPCR): p = 0.25</a:t>
            </a:r>
          </a:p>
          <a:p>
            <a:r>
              <a:rPr lang="en-US" sz="800" dirty="0" smtClean="0"/>
              <a:t>BGI vs </a:t>
            </a:r>
            <a:r>
              <a:rPr lang="en-US" sz="800" dirty="0" err="1" smtClean="0"/>
              <a:t>Norgen</a:t>
            </a:r>
            <a:r>
              <a:rPr lang="en-US" sz="800" dirty="0" smtClean="0"/>
              <a:t> N1 RT-qPCR (BGI extraction): p = 0.0156 </a:t>
            </a:r>
          </a:p>
          <a:p>
            <a:r>
              <a:rPr lang="en-US" sz="800" dirty="0"/>
              <a:t>BGI vs </a:t>
            </a:r>
            <a:r>
              <a:rPr lang="en-US" sz="800" dirty="0" err="1"/>
              <a:t>Norgen</a:t>
            </a:r>
            <a:r>
              <a:rPr lang="en-US" sz="800" dirty="0"/>
              <a:t> N1 RT-qPCR (BGI extraction): p = </a:t>
            </a:r>
            <a:r>
              <a:rPr lang="en-US" sz="800" dirty="0" smtClean="0"/>
              <a:t>0.0625 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3389391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9080051"/>
              </p:ext>
            </p:extLst>
          </p:nvPr>
        </p:nvGraphicFramePr>
        <p:xfrm>
          <a:off x="447948" y="2139865"/>
          <a:ext cx="3464444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12185-DE76-4E28-94B2-BD2CD19D4DA9}" type="slidenum">
              <a:rPr lang="en-US" smtClean="0"/>
              <a:t>2</a:t>
            </a:fld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313135" y="636086"/>
            <a:ext cx="269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A</a:t>
            </a:r>
            <a:endParaRPr lang="en-US" sz="1100" b="1" dirty="0"/>
          </a:p>
        </p:txBody>
      </p:sp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2273933"/>
              </p:ext>
            </p:extLst>
          </p:nvPr>
        </p:nvGraphicFramePr>
        <p:xfrm>
          <a:off x="559544" y="896094"/>
          <a:ext cx="2259856" cy="8657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027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5319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5319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5319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18959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1" i="0" u="none" strike="noStrike" dirty="0" smtClean="0">
                          <a:solidFill>
                            <a:schemeClr val="bg1"/>
                          </a:solidFill>
                          <a:effectLst/>
                          <a:latin typeface="Calibri"/>
                        </a:rPr>
                        <a:t>Primers:  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S1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SH</a:t>
                      </a:r>
                      <a:r>
                        <a:rPr lang="en-US" sz="800" u="none" strike="noStrike" baseline="0" dirty="0" smtClean="0">
                          <a:effectLst/>
                        </a:rPr>
                        <a:t> N1</a:t>
                      </a:r>
                      <a:endParaRPr lang="en-US" sz="800" u="none" strike="noStrike" dirty="0" smtClean="0">
                        <a:effectLst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SH</a:t>
                      </a:r>
                      <a:r>
                        <a:rPr lang="en-US" sz="800" u="none" strike="noStrike" baseline="0" dirty="0" smtClean="0">
                          <a:effectLst/>
                        </a:rPr>
                        <a:t> S1</a:t>
                      </a:r>
                      <a:endParaRPr lang="en-US" sz="800" u="none" strike="noStrike" dirty="0" smtClean="0">
                        <a:effectLst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22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10 copies/</a:t>
                      </a:r>
                      <a:r>
                        <a:rPr lang="el-GR" sz="800" u="none" strike="noStrike">
                          <a:effectLst/>
                        </a:rPr>
                        <a:t>μ</a:t>
                      </a:r>
                      <a:r>
                        <a:rPr lang="en-US" sz="800" u="none" strike="noStrike">
                          <a:effectLst/>
                        </a:rPr>
                        <a:t>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10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10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10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822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5 copies/</a:t>
                      </a:r>
                      <a:r>
                        <a:rPr lang="el-GR" sz="800" u="none" strike="noStrike">
                          <a:effectLst/>
                        </a:rPr>
                        <a:t>μ</a:t>
                      </a:r>
                      <a:r>
                        <a:rPr lang="en-US" sz="800" u="none" strike="noStrike">
                          <a:effectLst/>
                        </a:rPr>
                        <a:t>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9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9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9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822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2.5 copies/</a:t>
                      </a:r>
                      <a:r>
                        <a:rPr lang="el-GR" sz="800" u="none" strike="noStrike" dirty="0">
                          <a:effectLst/>
                        </a:rPr>
                        <a:t>μ</a:t>
                      </a:r>
                      <a:r>
                        <a:rPr lang="en-US" sz="800" u="none" strike="noStrike" dirty="0">
                          <a:effectLst/>
                        </a:rPr>
                        <a:t>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7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7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 smtClean="0">
                          <a:effectLst/>
                        </a:rPr>
                        <a:t>4/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5348610"/>
              </p:ext>
            </p:extLst>
          </p:nvPr>
        </p:nvGraphicFramePr>
        <p:xfrm>
          <a:off x="3133172" y="684119"/>
          <a:ext cx="1551528" cy="1551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2659971"/>
              </p:ext>
            </p:extLst>
          </p:nvPr>
        </p:nvGraphicFramePr>
        <p:xfrm>
          <a:off x="4705432" y="684119"/>
          <a:ext cx="1595750" cy="1551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304800" y="4078992"/>
            <a:ext cx="272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D</a:t>
            </a:r>
            <a:endParaRPr lang="en-US" sz="1100" b="1" dirty="0"/>
          </a:p>
        </p:txBody>
      </p:sp>
      <p:grpSp>
        <p:nvGrpSpPr>
          <p:cNvPr id="20" name="Group 19"/>
          <p:cNvGrpSpPr/>
          <p:nvPr/>
        </p:nvGrpSpPr>
        <p:grpSpPr>
          <a:xfrm>
            <a:off x="333501" y="4307592"/>
            <a:ext cx="5722580" cy="2579678"/>
            <a:chOff x="485901" y="3211522"/>
            <a:chExt cx="5722580" cy="2579678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58548" y="3211522"/>
              <a:ext cx="2469409" cy="123470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09598" y="3211522"/>
              <a:ext cx="2788041" cy="1234702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2191300" y="3505200"/>
              <a:ext cx="12377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24 (specific peak)</a:t>
              </a:r>
              <a:endParaRPr lang="en-US" sz="9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294082" y="3663932"/>
              <a:ext cx="5193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17</a:t>
              </a:r>
              <a:endParaRPr lang="en-US" sz="9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797662" y="3635766"/>
              <a:ext cx="4601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24</a:t>
              </a:r>
              <a:endParaRPr lang="en-US" sz="9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582353" y="3866597"/>
              <a:ext cx="626128" cy="235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NTC</a:t>
              </a:r>
              <a:endParaRPr lang="en-US" sz="9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403930" y="3810585"/>
              <a:ext cx="11038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17 (non-specific)</a:t>
              </a:r>
              <a:endParaRPr lang="en-US" sz="9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-7118" y="3740541"/>
              <a:ext cx="12891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S1 Primers (Lancet)</a:t>
              </a:r>
              <a:endParaRPr lang="en-US" sz="1100" dirty="0"/>
            </a:p>
          </p:txBody>
        </p:sp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19762" y="4556496"/>
              <a:ext cx="2788042" cy="1234704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1428095" y="4797281"/>
              <a:ext cx="11764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24 (specific peak)</a:t>
              </a:r>
              <a:endParaRPr lang="en-US" sz="900" dirty="0"/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114004" y="5055473"/>
              <a:ext cx="10054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SH N1 Primers</a:t>
              </a:r>
              <a:endParaRPr lang="en-US" sz="11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120140" y="5087112"/>
              <a:ext cx="12420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O17 (non-specific)</a:t>
              </a:r>
              <a:endParaRPr lang="en-US" sz="900" dirty="0"/>
            </a:p>
          </p:txBody>
        </p:sp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63471" y="4566350"/>
              <a:ext cx="2436891" cy="1218445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5208372" y="5186516"/>
              <a:ext cx="4443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17</a:t>
              </a:r>
              <a:endParaRPr lang="en-US" sz="9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768961" y="5029200"/>
              <a:ext cx="4964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24</a:t>
              </a:r>
              <a:endParaRPr lang="en-US" sz="9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606104" y="5304714"/>
              <a:ext cx="4587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NTC</a:t>
              </a:r>
              <a:endParaRPr lang="en-US" sz="900" dirty="0"/>
            </a:p>
          </p:txBody>
        </p:sp>
        <p:cxnSp>
          <p:nvCxnSpPr>
            <p:cNvPr id="43" name="Straight Connector 42"/>
            <p:cNvCxnSpPr/>
            <p:nvPr/>
          </p:nvCxnSpPr>
          <p:spPr>
            <a:xfrm flipH="1">
              <a:off x="2144412" y="3633079"/>
              <a:ext cx="112482" cy="76200"/>
            </a:xfrm>
            <a:prstGeom prst="line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 flipH="1">
              <a:off x="2379258" y="3944112"/>
              <a:ext cx="112482" cy="76200"/>
            </a:xfrm>
            <a:prstGeom prst="line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2439088" y="4919378"/>
              <a:ext cx="96159" cy="82331"/>
            </a:xfrm>
            <a:prstGeom prst="line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2131929" y="5210521"/>
              <a:ext cx="96159" cy="82331"/>
            </a:xfrm>
            <a:prstGeom prst="line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 46"/>
          <p:cNvGrpSpPr/>
          <p:nvPr/>
        </p:nvGrpSpPr>
        <p:grpSpPr>
          <a:xfrm>
            <a:off x="354246" y="6940465"/>
            <a:ext cx="5586273" cy="1289135"/>
            <a:chOff x="506646" y="6158437"/>
            <a:chExt cx="5586273" cy="1289135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27983" y="6189110"/>
              <a:ext cx="2791434" cy="1190841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711237" y="6189110"/>
              <a:ext cx="2381682" cy="1190841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>
              <a:off x="5480101" y="6779450"/>
              <a:ext cx="5759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32</a:t>
              </a:r>
              <a:endParaRPr lang="en-US" sz="9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797661" y="6676422"/>
              <a:ext cx="4344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24</a:t>
              </a:r>
              <a:endParaRPr lang="en-US" sz="9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424389" y="6703368"/>
              <a:ext cx="11070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32</a:t>
              </a:r>
            </a:p>
            <a:p>
              <a:r>
                <a:rPr lang="en-US" sz="900" dirty="0" smtClean="0"/>
                <a:t>(non-specific peak)</a:t>
              </a:r>
              <a:endParaRPr lang="en-US" sz="900" dirty="0"/>
            </a:p>
          </p:txBody>
        </p:sp>
        <p:sp>
          <p:nvSpPr>
            <p:cNvPr id="53" name="TextBox 52"/>
            <p:cNvSpPr txBox="1"/>
            <p:nvPr/>
          </p:nvSpPr>
          <p:spPr>
            <a:xfrm rot="16200000">
              <a:off x="-7117" y="6672200"/>
              <a:ext cx="128913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/>
                <a:t>S1 Primers (Lancet)</a:t>
              </a:r>
              <a:endParaRPr lang="en-US" sz="11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181225" y="6369993"/>
              <a:ext cx="1143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24 (specific peak)</a:t>
              </a:r>
              <a:endParaRPr lang="en-US" sz="900" dirty="0"/>
            </a:p>
          </p:txBody>
        </p:sp>
        <p:cxnSp>
          <p:nvCxnSpPr>
            <p:cNvPr id="55" name="Straight Connector 54"/>
            <p:cNvCxnSpPr/>
            <p:nvPr/>
          </p:nvCxnSpPr>
          <p:spPr>
            <a:xfrm flipH="1">
              <a:off x="2394204" y="6836795"/>
              <a:ext cx="112482" cy="76200"/>
            </a:xfrm>
            <a:prstGeom prst="line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2184232" y="6521450"/>
              <a:ext cx="11070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032 (specific peak)</a:t>
              </a:r>
              <a:endParaRPr lang="en-US" sz="900" dirty="0"/>
            </a:p>
          </p:txBody>
        </p:sp>
        <p:cxnSp>
          <p:nvCxnSpPr>
            <p:cNvPr id="57" name="Straight Connector 56"/>
            <p:cNvCxnSpPr/>
            <p:nvPr/>
          </p:nvCxnSpPr>
          <p:spPr>
            <a:xfrm flipH="1">
              <a:off x="2144522" y="6665037"/>
              <a:ext cx="112482" cy="76200"/>
            </a:xfrm>
            <a:prstGeom prst="line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8" name="Straight Connector 57"/>
          <p:cNvCxnSpPr/>
          <p:nvPr/>
        </p:nvCxnSpPr>
        <p:spPr>
          <a:xfrm flipH="1">
            <a:off x="1990725" y="7451125"/>
            <a:ext cx="112482" cy="76200"/>
          </a:xfrm>
          <a:prstGeom prst="line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 flipH="1">
            <a:off x="1997838" y="7296436"/>
            <a:ext cx="112482" cy="76200"/>
          </a:xfrm>
          <a:prstGeom prst="line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2895600" y="640552"/>
            <a:ext cx="269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B</a:t>
            </a:r>
            <a:endParaRPr lang="en-US" sz="11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11032" y="2173298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C</a:t>
            </a:r>
            <a:endParaRPr lang="en-US" sz="11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310722" y="387265"/>
            <a:ext cx="57090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. </a:t>
            </a:r>
            <a:r>
              <a:rPr lang="en-US" sz="1400" b="1" dirty="0" smtClean="0"/>
              <a:t>S2 </a:t>
            </a:r>
            <a:r>
              <a:rPr lang="en-US" sz="1400" b="1" dirty="0"/>
              <a:t>SYBR green detection of SARS-CoV-2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009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832</TotalTime>
  <Words>525</Words>
  <Application>Microsoft Office PowerPoint</Application>
  <PresentationFormat>On-screen Show (4:3)</PresentationFormat>
  <Paragraphs>19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l Pearson</dc:creator>
  <cp:lastModifiedBy>Yuvaraj K.</cp:lastModifiedBy>
  <cp:revision>216</cp:revision>
  <cp:lastPrinted>2021-01-19T18:48:25Z</cp:lastPrinted>
  <dcterms:created xsi:type="dcterms:W3CDTF">2020-04-16T18:48:38Z</dcterms:created>
  <dcterms:modified xsi:type="dcterms:W3CDTF">2021-05-12T02:53:25Z</dcterms:modified>
</cp:coreProperties>
</file>